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  <p:sldId id="305" r:id="rId3"/>
    <p:sldId id="256" r:id="rId4"/>
    <p:sldId id="257" r:id="rId5"/>
    <p:sldId id="258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mi\Desktop\Laboratorio\Proyectos\juanjo\analisis%20actina%20septiembre%2021\blebs\ppt%20adicional\imagen%202%20perfil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mi\Desktop\Laboratorio\Proyectos\juanjo\analisis%20actina%20septiembre%2021\blebs\ppt%20adicional\imagen%2026%20%20perfil.csv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mi\Desktop\Laboratorio\Proyectos\juanjo\analisis%20actina%20septiembre%2021\blebs\ppt%20adicional\imagen%2033%20perfil.csv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mi\Desktop\Laboratorio\Proyectos\juanjo\analisis%20actina%20septiembre%2021\blebs\ppt%20adicional\imagen%2041%20perfil.csv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32140651536205"/>
          <c:y val="4.2395329436746336E-2"/>
          <c:w val="0.83318839740620654"/>
          <c:h val="0.7340614425161060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imagen 2 perfil'!$B$1</c:f>
              <c:strCache>
                <c:ptCount val="1"/>
                <c:pt idx="0">
                  <c:v>Gray_Value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'imagen 2 perfil'!$A$2:$A$128</c:f>
              <c:numCache>
                <c:formatCode>General</c:formatCode>
                <c:ptCount val="127"/>
                <c:pt idx="0">
                  <c:v>0</c:v>
                </c:pt>
                <c:pt idx="1">
                  <c:v>8.2000000000000003E-2</c:v>
                </c:pt>
                <c:pt idx="2">
                  <c:v>0.16400000000000001</c:v>
                </c:pt>
                <c:pt idx="3">
                  <c:v>0.246</c:v>
                </c:pt>
                <c:pt idx="4">
                  <c:v>0.32800000000000001</c:v>
                </c:pt>
                <c:pt idx="5">
                  <c:v>0.41</c:v>
                </c:pt>
                <c:pt idx="6">
                  <c:v>0.49199999999999999</c:v>
                </c:pt>
                <c:pt idx="7">
                  <c:v>0.57399999999999995</c:v>
                </c:pt>
                <c:pt idx="8">
                  <c:v>0.65600000000000003</c:v>
                </c:pt>
                <c:pt idx="9">
                  <c:v>0.73799999999999999</c:v>
                </c:pt>
                <c:pt idx="10">
                  <c:v>0.82</c:v>
                </c:pt>
                <c:pt idx="11">
                  <c:v>0.90200000000000002</c:v>
                </c:pt>
                <c:pt idx="12">
                  <c:v>0.98399999999999999</c:v>
                </c:pt>
                <c:pt idx="13">
                  <c:v>1.0660000000000001</c:v>
                </c:pt>
                <c:pt idx="14">
                  <c:v>1.1479999999999999</c:v>
                </c:pt>
                <c:pt idx="15">
                  <c:v>1.23</c:v>
                </c:pt>
                <c:pt idx="16">
                  <c:v>1.3120000000000001</c:v>
                </c:pt>
                <c:pt idx="17">
                  <c:v>1.3939999999999999</c:v>
                </c:pt>
                <c:pt idx="18">
                  <c:v>1.476</c:v>
                </c:pt>
                <c:pt idx="19">
                  <c:v>1.5580000000000001</c:v>
                </c:pt>
                <c:pt idx="20">
                  <c:v>1.64</c:v>
                </c:pt>
                <c:pt idx="21">
                  <c:v>1.722</c:v>
                </c:pt>
                <c:pt idx="22">
                  <c:v>1.804</c:v>
                </c:pt>
                <c:pt idx="23">
                  <c:v>1.8859999999999999</c:v>
                </c:pt>
                <c:pt idx="24">
                  <c:v>1.968</c:v>
                </c:pt>
                <c:pt idx="25">
                  <c:v>2.0499999999999998</c:v>
                </c:pt>
                <c:pt idx="26">
                  <c:v>2.1320000000000001</c:v>
                </c:pt>
                <c:pt idx="27">
                  <c:v>2.214</c:v>
                </c:pt>
                <c:pt idx="28">
                  <c:v>2.2959999999999998</c:v>
                </c:pt>
                <c:pt idx="29">
                  <c:v>2.3780000000000001</c:v>
                </c:pt>
                <c:pt idx="30">
                  <c:v>2.46</c:v>
                </c:pt>
                <c:pt idx="31">
                  <c:v>2.5419999999999998</c:v>
                </c:pt>
                <c:pt idx="32">
                  <c:v>2.6240000000000001</c:v>
                </c:pt>
                <c:pt idx="33">
                  <c:v>2.706</c:v>
                </c:pt>
                <c:pt idx="34">
                  <c:v>2.7879999999999998</c:v>
                </c:pt>
                <c:pt idx="35">
                  <c:v>2.87</c:v>
                </c:pt>
                <c:pt idx="36">
                  <c:v>2.952</c:v>
                </c:pt>
                <c:pt idx="37">
                  <c:v>3.0339999999999998</c:v>
                </c:pt>
                <c:pt idx="38">
                  <c:v>3.1160000000000001</c:v>
                </c:pt>
                <c:pt idx="39">
                  <c:v>3.198</c:v>
                </c:pt>
                <c:pt idx="40">
                  <c:v>3.28</c:v>
                </c:pt>
                <c:pt idx="41">
                  <c:v>3.3620000000000001</c:v>
                </c:pt>
                <c:pt idx="42">
                  <c:v>3.444</c:v>
                </c:pt>
                <c:pt idx="43">
                  <c:v>3.5259999999999998</c:v>
                </c:pt>
                <c:pt idx="44">
                  <c:v>3.6080000000000001</c:v>
                </c:pt>
                <c:pt idx="45">
                  <c:v>3.69</c:v>
                </c:pt>
                <c:pt idx="46">
                  <c:v>3.7719999999999998</c:v>
                </c:pt>
                <c:pt idx="47">
                  <c:v>3.8540000000000001</c:v>
                </c:pt>
                <c:pt idx="48">
                  <c:v>3.9359999999999999</c:v>
                </c:pt>
                <c:pt idx="49">
                  <c:v>4.0179999999999998</c:v>
                </c:pt>
                <c:pt idx="50">
                  <c:v>4.0999999999999996</c:v>
                </c:pt>
                <c:pt idx="51">
                  <c:v>4.1820000000000004</c:v>
                </c:pt>
                <c:pt idx="52">
                  <c:v>4.2640000000000002</c:v>
                </c:pt>
                <c:pt idx="53">
                  <c:v>4.3460000000000001</c:v>
                </c:pt>
                <c:pt idx="54">
                  <c:v>4.4279999999999999</c:v>
                </c:pt>
                <c:pt idx="55">
                  <c:v>4.51</c:v>
                </c:pt>
                <c:pt idx="56">
                  <c:v>4.5919999999999996</c:v>
                </c:pt>
                <c:pt idx="57">
                  <c:v>4.6740000000000004</c:v>
                </c:pt>
                <c:pt idx="58">
                  <c:v>4.7560000000000002</c:v>
                </c:pt>
                <c:pt idx="59">
                  <c:v>4.8380000000000001</c:v>
                </c:pt>
                <c:pt idx="60">
                  <c:v>4.92</c:v>
                </c:pt>
                <c:pt idx="61">
                  <c:v>5.0019999999999998</c:v>
                </c:pt>
                <c:pt idx="62">
                  <c:v>5.0839999999999996</c:v>
                </c:pt>
                <c:pt idx="63">
                  <c:v>5.1660000000000004</c:v>
                </c:pt>
                <c:pt idx="64">
                  <c:v>5.2480000000000002</c:v>
                </c:pt>
                <c:pt idx="65">
                  <c:v>5.33</c:v>
                </c:pt>
                <c:pt idx="66">
                  <c:v>5.4119999999999999</c:v>
                </c:pt>
                <c:pt idx="67">
                  <c:v>5.4939999999999998</c:v>
                </c:pt>
                <c:pt idx="68">
                  <c:v>5.5759999999999996</c:v>
                </c:pt>
                <c:pt idx="69">
                  <c:v>5.6580000000000004</c:v>
                </c:pt>
                <c:pt idx="70">
                  <c:v>5.74</c:v>
                </c:pt>
                <c:pt idx="71">
                  <c:v>5.8220000000000001</c:v>
                </c:pt>
                <c:pt idx="72">
                  <c:v>5.9039999999999999</c:v>
                </c:pt>
                <c:pt idx="73">
                  <c:v>5.9859999999999998</c:v>
                </c:pt>
                <c:pt idx="74">
                  <c:v>6.0679999999999996</c:v>
                </c:pt>
                <c:pt idx="75">
                  <c:v>6.15</c:v>
                </c:pt>
                <c:pt idx="76">
                  <c:v>6.2320000000000002</c:v>
                </c:pt>
                <c:pt idx="77">
                  <c:v>6.3140000000000001</c:v>
                </c:pt>
                <c:pt idx="78">
                  <c:v>6.3959999999999999</c:v>
                </c:pt>
                <c:pt idx="79">
                  <c:v>6.4779999999999998</c:v>
                </c:pt>
                <c:pt idx="80">
                  <c:v>6.56</c:v>
                </c:pt>
                <c:pt idx="81">
                  <c:v>6.6420000000000003</c:v>
                </c:pt>
                <c:pt idx="82">
                  <c:v>6.7240000000000002</c:v>
                </c:pt>
                <c:pt idx="83">
                  <c:v>6.806</c:v>
                </c:pt>
                <c:pt idx="84">
                  <c:v>6.8879999999999999</c:v>
                </c:pt>
                <c:pt idx="85">
                  <c:v>6.97</c:v>
                </c:pt>
                <c:pt idx="86">
                  <c:v>7.0519999999999996</c:v>
                </c:pt>
                <c:pt idx="87">
                  <c:v>7.1340000000000003</c:v>
                </c:pt>
                <c:pt idx="88">
                  <c:v>7.2160000000000002</c:v>
                </c:pt>
                <c:pt idx="89">
                  <c:v>7.298</c:v>
                </c:pt>
                <c:pt idx="90">
                  <c:v>7.38</c:v>
                </c:pt>
                <c:pt idx="91">
                  <c:v>7.4619999999999997</c:v>
                </c:pt>
                <c:pt idx="92">
                  <c:v>7.5439999999999996</c:v>
                </c:pt>
                <c:pt idx="93">
                  <c:v>7.6260000000000003</c:v>
                </c:pt>
                <c:pt idx="94">
                  <c:v>7.7080000000000002</c:v>
                </c:pt>
                <c:pt idx="95">
                  <c:v>7.79</c:v>
                </c:pt>
                <c:pt idx="96">
                  <c:v>7.8719999999999999</c:v>
                </c:pt>
                <c:pt idx="97">
                  <c:v>7.9539999999999997</c:v>
                </c:pt>
                <c:pt idx="98">
                  <c:v>8.0359999999999996</c:v>
                </c:pt>
                <c:pt idx="99">
                  <c:v>8.1180000000000003</c:v>
                </c:pt>
                <c:pt idx="100">
                  <c:v>8.1999999999999993</c:v>
                </c:pt>
                <c:pt idx="101">
                  <c:v>8.282</c:v>
                </c:pt>
                <c:pt idx="102">
                  <c:v>8.3640000000000008</c:v>
                </c:pt>
                <c:pt idx="103">
                  <c:v>8.4459999999999997</c:v>
                </c:pt>
                <c:pt idx="104">
                  <c:v>8.5280000000000005</c:v>
                </c:pt>
                <c:pt idx="105">
                  <c:v>8.61</c:v>
                </c:pt>
                <c:pt idx="106">
                  <c:v>8.6920000000000002</c:v>
                </c:pt>
                <c:pt idx="107">
                  <c:v>8.7739999999999991</c:v>
                </c:pt>
                <c:pt idx="108">
                  <c:v>8.8559999999999999</c:v>
                </c:pt>
                <c:pt idx="109">
                  <c:v>8.9380000000000006</c:v>
                </c:pt>
                <c:pt idx="110">
                  <c:v>9.02</c:v>
                </c:pt>
                <c:pt idx="111">
                  <c:v>9.1020000000000003</c:v>
                </c:pt>
                <c:pt idx="112">
                  <c:v>9.1839999999999993</c:v>
                </c:pt>
                <c:pt idx="113">
                  <c:v>9.266</c:v>
                </c:pt>
                <c:pt idx="114">
                  <c:v>9.3480000000000008</c:v>
                </c:pt>
                <c:pt idx="115">
                  <c:v>9.43</c:v>
                </c:pt>
                <c:pt idx="116">
                  <c:v>9.5120000000000005</c:v>
                </c:pt>
                <c:pt idx="117">
                  <c:v>9.5939999999999994</c:v>
                </c:pt>
                <c:pt idx="118">
                  <c:v>9.6760000000000002</c:v>
                </c:pt>
                <c:pt idx="119">
                  <c:v>9.7579999999999991</c:v>
                </c:pt>
                <c:pt idx="120">
                  <c:v>9.84</c:v>
                </c:pt>
                <c:pt idx="121">
                  <c:v>9.9220000000000006</c:v>
                </c:pt>
                <c:pt idx="122">
                  <c:v>10.004</c:v>
                </c:pt>
                <c:pt idx="123">
                  <c:v>10.086</c:v>
                </c:pt>
                <c:pt idx="124">
                  <c:v>10.167999999999999</c:v>
                </c:pt>
                <c:pt idx="125">
                  <c:v>10.25</c:v>
                </c:pt>
                <c:pt idx="126">
                  <c:v>10.332000000000001</c:v>
                </c:pt>
              </c:numCache>
            </c:numRef>
          </c:xVal>
          <c:yVal>
            <c:numRef>
              <c:f>'imagen 2 perfil'!$B$2:$B$128</c:f>
              <c:numCache>
                <c:formatCode>General</c:formatCode>
                <c:ptCount val="127"/>
                <c:pt idx="0">
                  <c:v>65.256900000000002</c:v>
                </c:pt>
                <c:pt idx="1">
                  <c:v>56.5381</c:v>
                </c:pt>
                <c:pt idx="2">
                  <c:v>61.276600000000002</c:v>
                </c:pt>
                <c:pt idx="3">
                  <c:v>61.445300000000003</c:v>
                </c:pt>
                <c:pt idx="4">
                  <c:v>64.131699999999995</c:v>
                </c:pt>
                <c:pt idx="5">
                  <c:v>51.165799999999997</c:v>
                </c:pt>
                <c:pt idx="6">
                  <c:v>57.829300000000003</c:v>
                </c:pt>
                <c:pt idx="7">
                  <c:v>66.129499999999993</c:v>
                </c:pt>
                <c:pt idx="8">
                  <c:v>62.474499999999999</c:v>
                </c:pt>
                <c:pt idx="9">
                  <c:v>68.679199999999994</c:v>
                </c:pt>
                <c:pt idx="10">
                  <c:v>52.837200000000003</c:v>
                </c:pt>
                <c:pt idx="11">
                  <c:v>61.436399999999999</c:v>
                </c:pt>
                <c:pt idx="12">
                  <c:v>74.495800000000003</c:v>
                </c:pt>
                <c:pt idx="13">
                  <c:v>69.802499999999995</c:v>
                </c:pt>
                <c:pt idx="14">
                  <c:v>83.2577</c:v>
                </c:pt>
                <c:pt idx="15">
                  <c:v>81.039100000000005</c:v>
                </c:pt>
                <c:pt idx="16">
                  <c:v>75.810100000000006</c:v>
                </c:pt>
                <c:pt idx="17">
                  <c:v>73.907600000000002</c:v>
                </c:pt>
                <c:pt idx="18">
                  <c:v>70.479100000000003</c:v>
                </c:pt>
                <c:pt idx="19">
                  <c:v>61.722499999999997</c:v>
                </c:pt>
                <c:pt idx="20">
                  <c:v>54.302500000000002</c:v>
                </c:pt>
                <c:pt idx="21">
                  <c:v>57.665399999999998</c:v>
                </c:pt>
                <c:pt idx="22">
                  <c:v>55.496099999999998</c:v>
                </c:pt>
                <c:pt idx="23">
                  <c:v>54.8904</c:v>
                </c:pt>
                <c:pt idx="24">
                  <c:v>45.887900000000002</c:v>
                </c:pt>
                <c:pt idx="25">
                  <c:v>50.894799999999996</c:v>
                </c:pt>
                <c:pt idx="26">
                  <c:v>52.514699999999998</c:v>
                </c:pt>
                <c:pt idx="27">
                  <c:v>54.902999999999999</c:v>
                </c:pt>
                <c:pt idx="28">
                  <c:v>49.319299999999998</c:v>
                </c:pt>
                <c:pt idx="29">
                  <c:v>47.201700000000002</c:v>
                </c:pt>
                <c:pt idx="30">
                  <c:v>46.423000000000002</c:v>
                </c:pt>
                <c:pt idx="31">
                  <c:v>41.575299999999999</c:v>
                </c:pt>
                <c:pt idx="32">
                  <c:v>39.273000000000003</c:v>
                </c:pt>
                <c:pt idx="33">
                  <c:v>37.063200000000002</c:v>
                </c:pt>
                <c:pt idx="34">
                  <c:v>41.712299999999999</c:v>
                </c:pt>
                <c:pt idx="35">
                  <c:v>42.363700000000001</c:v>
                </c:pt>
                <c:pt idx="36">
                  <c:v>47.5869</c:v>
                </c:pt>
                <c:pt idx="37">
                  <c:v>42.165999999999997</c:v>
                </c:pt>
                <c:pt idx="38">
                  <c:v>47.215400000000002</c:v>
                </c:pt>
                <c:pt idx="39">
                  <c:v>46.397100000000002</c:v>
                </c:pt>
                <c:pt idx="40">
                  <c:v>44.279699999999998</c:v>
                </c:pt>
                <c:pt idx="41">
                  <c:v>42.553699999999999</c:v>
                </c:pt>
                <c:pt idx="42">
                  <c:v>47.994300000000003</c:v>
                </c:pt>
                <c:pt idx="43">
                  <c:v>44.275399999999998</c:v>
                </c:pt>
                <c:pt idx="44">
                  <c:v>45.074199999999998</c:v>
                </c:pt>
                <c:pt idx="45">
                  <c:v>39.574800000000003</c:v>
                </c:pt>
                <c:pt idx="46">
                  <c:v>43.438699999999997</c:v>
                </c:pt>
                <c:pt idx="47">
                  <c:v>43.236699999999999</c:v>
                </c:pt>
                <c:pt idx="48">
                  <c:v>43.374299999999998</c:v>
                </c:pt>
                <c:pt idx="49">
                  <c:v>43.460900000000002</c:v>
                </c:pt>
                <c:pt idx="50">
                  <c:v>45.0456</c:v>
                </c:pt>
                <c:pt idx="51">
                  <c:v>44.879800000000003</c:v>
                </c:pt>
                <c:pt idx="52">
                  <c:v>42.618600000000001</c:v>
                </c:pt>
                <c:pt idx="53">
                  <c:v>44.491</c:v>
                </c:pt>
                <c:pt idx="54">
                  <c:v>45.805700000000002</c:v>
                </c:pt>
                <c:pt idx="55">
                  <c:v>48.113799999999998</c:v>
                </c:pt>
                <c:pt idx="56">
                  <c:v>48.394500000000001</c:v>
                </c:pt>
                <c:pt idx="57">
                  <c:v>45.677999999999997</c:v>
                </c:pt>
                <c:pt idx="58">
                  <c:v>50.763100000000001</c:v>
                </c:pt>
                <c:pt idx="59">
                  <c:v>52.8611</c:v>
                </c:pt>
                <c:pt idx="60">
                  <c:v>50.695399999999999</c:v>
                </c:pt>
                <c:pt idx="61">
                  <c:v>48.888300000000001</c:v>
                </c:pt>
                <c:pt idx="62">
                  <c:v>54.161799999999999</c:v>
                </c:pt>
                <c:pt idx="63">
                  <c:v>54.012500000000003</c:v>
                </c:pt>
                <c:pt idx="64">
                  <c:v>47.685299999999998</c:v>
                </c:pt>
                <c:pt idx="65">
                  <c:v>48.887300000000003</c:v>
                </c:pt>
                <c:pt idx="66">
                  <c:v>44.622700000000002</c:v>
                </c:pt>
                <c:pt idx="67">
                  <c:v>48.321100000000001</c:v>
                </c:pt>
                <c:pt idx="68">
                  <c:v>52.7468</c:v>
                </c:pt>
                <c:pt idx="69">
                  <c:v>49.403700000000001</c:v>
                </c:pt>
                <c:pt idx="70">
                  <c:v>45.195500000000003</c:v>
                </c:pt>
                <c:pt idx="71">
                  <c:v>47.219799999999999</c:v>
                </c:pt>
                <c:pt idx="72">
                  <c:v>47.113700000000001</c:v>
                </c:pt>
                <c:pt idx="73">
                  <c:v>44.370199999999997</c:v>
                </c:pt>
                <c:pt idx="74">
                  <c:v>55.071800000000003</c:v>
                </c:pt>
                <c:pt idx="75">
                  <c:v>58.848599999999998</c:v>
                </c:pt>
                <c:pt idx="76">
                  <c:v>50.558599999999998</c:v>
                </c:pt>
                <c:pt idx="77">
                  <c:v>56.617199999999997</c:v>
                </c:pt>
                <c:pt idx="78">
                  <c:v>56.466900000000003</c:v>
                </c:pt>
                <c:pt idx="79">
                  <c:v>59.807400000000001</c:v>
                </c:pt>
                <c:pt idx="80">
                  <c:v>53.034100000000002</c:v>
                </c:pt>
                <c:pt idx="81">
                  <c:v>51.299500000000002</c:v>
                </c:pt>
                <c:pt idx="82">
                  <c:v>50.1494</c:v>
                </c:pt>
                <c:pt idx="83">
                  <c:v>57.319699999999997</c:v>
                </c:pt>
                <c:pt idx="84">
                  <c:v>57.368600000000001</c:v>
                </c:pt>
                <c:pt idx="85">
                  <c:v>57.216000000000001</c:v>
                </c:pt>
                <c:pt idx="86">
                  <c:v>58.0289</c:v>
                </c:pt>
                <c:pt idx="87">
                  <c:v>55.432899999999997</c:v>
                </c:pt>
                <c:pt idx="88">
                  <c:v>48.706400000000002</c:v>
                </c:pt>
                <c:pt idx="89">
                  <c:v>49.414400000000001</c:v>
                </c:pt>
                <c:pt idx="90">
                  <c:v>51.038200000000003</c:v>
                </c:pt>
                <c:pt idx="91">
                  <c:v>42.335700000000003</c:v>
                </c:pt>
                <c:pt idx="92">
                  <c:v>44.100499999999997</c:v>
                </c:pt>
                <c:pt idx="93">
                  <c:v>50.248899999999999</c:v>
                </c:pt>
                <c:pt idx="94">
                  <c:v>49.428800000000003</c:v>
                </c:pt>
                <c:pt idx="95">
                  <c:v>52.407200000000003</c:v>
                </c:pt>
                <c:pt idx="96">
                  <c:v>56.588000000000001</c:v>
                </c:pt>
                <c:pt idx="97">
                  <c:v>47.196100000000001</c:v>
                </c:pt>
                <c:pt idx="98">
                  <c:v>49.229799999999997</c:v>
                </c:pt>
                <c:pt idx="99">
                  <c:v>52.422499999999999</c:v>
                </c:pt>
                <c:pt idx="100">
                  <c:v>59.482900000000001</c:v>
                </c:pt>
                <c:pt idx="101">
                  <c:v>62.986600000000003</c:v>
                </c:pt>
                <c:pt idx="102">
                  <c:v>60.3322</c:v>
                </c:pt>
                <c:pt idx="103">
                  <c:v>62.031100000000002</c:v>
                </c:pt>
                <c:pt idx="104">
                  <c:v>57.972200000000001</c:v>
                </c:pt>
                <c:pt idx="105">
                  <c:v>62.2605</c:v>
                </c:pt>
                <c:pt idx="106">
                  <c:v>54.248699999999999</c:v>
                </c:pt>
                <c:pt idx="107">
                  <c:v>62.395499999999998</c:v>
                </c:pt>
                <c:pt idx="108">
                  <c:v>63.405299999999997</c:v>
                </c:pt>
                <c:pt idx="109">
                  <c:v>64.103200000000001</c:v>
                </c:pt>
                <c:pt idx="110">
                  <c:v>52.101999999999997</c:v>
                </c:pt>
                <c:pt idx="111">
                  <c:v>51.235199999999999</c:v>
                </c:pt>
                <c:pt idx="112">
                  <c:v>64.665999999999997</c:v>
                </c:pt>
                <c:pt idx="113">
                  <c:v>66.482500000000002</c:v>
                </c:pt>
                <c:pt idx="114">
                  <c:v>59.600099999999998</c:v>
                </c:pt>
                <c:pt idx="115">
                  <c:v>65.9405</c:v>
                </c:pt>
                <c:pt idx="116">
                  <c:v>71.371799999999993</c:v>
                </c:pt>
                <c:pt idx="117">
                  <c:v>65.441100000000006</c:v>
                </c:pt>
                <c:pt idx="118">
                  <c:v>64.033500000000004</c:v>
                </c:pt>
                <c:pt idx="119">
                  <c:v>74.225800000000007</c:v>
                </c:pt>
                <c:pt idx="120">
                  <c:v>69.954499999999996</c:v>
                </c:pt>
                <c:pt idx="121">
                  <c:v>70.697199999999995</c:v>
                </c:pt>
                <c:pt idx="122">
                  <c:v>75.723600000000005</c:v>
                </c:pt>
                <c:pt idx="123">
                  <c:v>81.024600000000007</c:v>
                </c:pt>
                <c:pt idx="124">
                  <c:v>78.199700000000007</c:v>
                </c:pt>
                <c:pt idx="125">
                  <c:v>75.246899999999997</c:v>
                </c:pt>
                <c:pt idx="126">
                  <c:v>7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A58-44AB-8770-4F84EC3DA7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75453808"/>
        <c:axId val="1675454224"/>
      </c:scatterChart>
      <c:valAx>
        <c:axId val="16754538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Distance (</a:t>
                </a:r>
                <a:r>
                  <a:rPr lang="el-GR" sz="1600"/>
                  <a:t>μ</a:t>
                </a:r>
                <a:r>
                  <a:rPr lang="es-AR" sz="1600"/>
                  <a:t>m)</a:t>
                </a:r>
                <a:endParaRPr lang="en-US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1675454224"/>
        <c:crosses val="autoZero"/>
        <c:crossBetween val="midCat"/>
      </c:valAx>
      <c:valAx>
        <c:axId val="1675454224"/>
        <c:scaling>
          <c:orientation val="minMax"/>
          <c:min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Fluorescence</a:t>
                </a:r>
                <a:r>
                  <a:rPr lang="en-US" sz="1600" baseline="0"/>
                  <a:t> intensity (a.u.)</a:t>
                </a:r>
                <a:endParaRPr lang="en-US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167545380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A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'imagen 26  perfil'!$B$1</c:f>
              <c:strCache>
                <c:ptCount val="1"/>
                <c:pt idx="0">
                  <c:v>Gray_Value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'imagen 26  perfil'!$A$2:$A$191</c:f>
              <c:numCache>
                <c:formatCode>General</c:formatCode>
                <c:ptCount val="190"/>
                <c:pt idx="0">
                  <c:v>0</c:v>
                </c:pt>
                <c:pt idx="1">
                  <c:v>0.10299999999999999</c:v>
                </c:pt>
                <c:pt idx="2">
                  <c:v>0.20599999999999999</c:v>
                </c:pt>
                <c:pt idx="3">
                  <c:v>0.309</c:v>
                </c:pt>
                <c:pt idx="4">
                  <c:v>0.41199999999999998</c:v>
                </c:pt>
                <c:pt idx="5">
                  <c:v>0.51500000000000001</c:v>
                </c:pt>
                <c:pt idx="6">
                  <c:v>0.61799999999999999</c:v>
                </c:pt>
                <c:pt idx="7">
                  <c:v>0.72099999999999997</c:v>
                </c:pt>
                <c:pt idx="8">
                  <c:v>0.82399999999999995</c:v>
                </c:pt>
                <c:pt idx="9">
                  <c:v>0.92700000000000005</c:v>
                </c:pt>
                <c:pt idx="10">
                  <c:v>1.03</c:v>
                </c:pt>
                <c:pt idx="11">
                  <c:v>1.133</c:v>
                </c:pt>
                <c:pt idx="12">
                  <c:v>1.236</c:v>
                </c:pt>
                <c:pt idx="13">
                  <c:v>1.339</c:v>
                </c:pt>
                <c:pt idx="14">
                  <c:v>1.4419999999999999</c:v>
                </c:pt>
                <c:pt idx="15">
                  <c:v>1.5449999999999999</c:v>
                </c:pt>
                <c:pt idx="16">
                  <c:v>1.6479999999999999</c:v>
                </c:pt>
                <c:pt idx="17">
                  <c:v>1.7509999999999999</c:v>
                </c:pt>
                <c:pt idx="18">
                  <c:v>1.8540000000000001</c:v>
                </c:pt>
                <c:pt idx="19">
                  <c:v>1.9570000000000001</c:v>
                </c:pt>
                <c:pt idx="20">
                  <c:v>2.06</c:v>
                </c:pt>
                <c:pt idx="21">
                  <c:v>2.1629999999999998</c:v>
                </c:pt>
                <c:pt idx="22">
                  <c:v>2.266</c:v>
                </c:pt>
                <c:pt idx="23">
                  <c:v>2.3690000000000002</c:v>
                </c:pt>
                <c:pt idx="24">
                  <c:v>2.472</c:v>
                </c:pt>
                <c:pt idx="25">
                  <c:v>2.5750000000000002</c:v>
                </c:pt>
                <c:pt idx="26">
                  <c:v>2.6779999999999999</c:v>
                </c:pt>
                <c:pt idx="27">
                  <c:v>2.7810000000000001</c:v>
                </c:pt>
                <c:pt idx="28">
                  <c:v>2.8839999999999999</c:v>
                </c:pt>
                <c:pt idx="29">
                  <c:v>2.9870000000000001</c:v>
                </c:pt>
                <c:pt idx="30">
                  <c:v>3.09</c:v>
                </c:pt>
                <c:pt idx="31">
                  <c:v>3.1930000000000001</c:v>
                </c:pt>
                <c:pt idx="32">
                  <c:v>3.2959999999999998</c:v>
                </c:pt>
                <c:pt idx="33">
                  <c:v>3.399</c:v>
                </c:pt>
                <c:pt idx="34">
                  <c:v>3.5019999999999998</c:v>
                </c:pt>
                <c:pt idx="35">
                  <c:v>3.605</c:v>
                </c:pt>
                <c:pt idx="36">
                  <c:v>3.7080000000000002</c:v>
                </c:pt>
                <c:pt idx="37">
                  <c:v>3.8109999999999999</c:v>
                </c:pt>
                <c:pt idx="38">
                  <c:v>3.9140000000000001</c:v>
                </c:pt>
                <c:pt idx="39">
                  <c:v>4.0170000000000003</c:v>
                </c:pt>
                <c:pt idx="40">
                  <c:v>4.12</c:v>
                </c:pt>
                <c:pt idx="41">
                  <c:v>4.2229999999999999</c:v>
                </c:pt>
                <c:pt idx="42">
                  <c:v>4.3259999999999996</c:v>
                </c:pt>
                <c:pt idx="43">
                  <c:v>4.4290000000000003</c:v>
                </c:pt>
                <c:pt idx="44">
                  <c:v>4.532</c:v>
                </c:pt>
                <c:pt idx="45">
                  <c:v>4.6349999999999998</c:v>
                </c:pt>
                <c:pt idx="46">
                  <c:v>4.7380000000000004</c:v>
                </c:pt>
                <c:pt idx="47">
                  <c:v>4.8410000000000002</c:v>
                </c:pt>
                <c:pt idx="48">
                  <c:v>4.944</c:v>
                </c:pt>
                <c:pt idx="49">
                  <c:v>5.0469999999999997</c:v>
                </c:pt>
                <c:pt idx="50">
                  <c:v>5.15</c:v>
                </c:pt>
                <c:pt idx="51">
                  <c:v>5.2530000000000001</c:v>
                </c:pt>
                <c:pt idx="52">
                  <c:v>5.3559999999999999</c:v>
                </c:pt>
                <c:pt idx="53">
                  <c:v>5.4589999999999996</c:v>
                </c:pt>
                <c:pt idx="54">
                  <c:v>5.5620000000000003</c:v>
                </c:pt>
                <c:pt idx="55">
                  <c:v>5.665</c:v>
                </c:pt>
                <c:pt idx="56">
                  <c:v>5.7679999999999998</c:v>
                </c:pt>
                <c:pt idx="57">
                  <c:v>5.8710000000000004</c:v>
                </c:pt>
                <c:pt idx="58">
                  <c:v>5.9740000000000002</c:v>
                </c:pt>
                <c:pt idx="59">
                  <c:v>6.077</c:v>
                </c:pt>
                <c:pt idx="60">
                  <c:v>6.18</c:v>
                </c:pt>
                <c:pt idx="61">
                  <c:v>6.2830000000000004</c:v>
                </c:pt>
                <c:pt idx="62">
                  <c:v>6.3860000000000001</c:v>
                </c:pt>
                <c:pt idx="63">
                  <c:v>6.4889999999999999</c:v>
                </c:pt>
                <c:pt idx="64">
                  <c:v>6.5919999999999996</c:v>
                </c:pt>
                <c:pt idx="65">
                  <c:v>6.6950000000000003</c:v>
                </c:pt>
                <c:pt idx="66">
                  <c:v>6.798</c:v>
                </c:pt>
                <c:pt idx="67">
                  <c:v>6.9009999999999998</c:v>
                </c:pt>
                <c:pt idx="68">
                  <c:v>7.0039999999999996</c:v>
                </c:pt>
                <c:pt idx="69">
                  <c:v>7.1070000000000002</c:v>
                </c:pt>
                <c:pt idx="70">
                  <c:v>7.21</c:v>
                </c:pt>
                <c:pt idx="71">
                  <c:v>7.3129999999999997</c:v>
                </c:pt>
                <c:pt idx="72">
                  <c:v>7.4160000000000004</c:v>
                </c:pt>
                <c:pt idx="73">
                  <c:v>7.5190000000000001</c:v>
                </c:pt>
                <c:pt idx="74">
                  <c:v>7.6219999999999999</c:v>
                </c:pt>
                <c:pt idx="75">
                  <c:v>7.7249999999999996</c:v>
                </c:pt>
                <c:pt idx="76">
                  <c:v>7.8280000000000003</c:v>
                </c:pt>
                <c:pt idx="77">
                  <c:v>7.931</c:v>
                </c:pt>
                <c:pt idx="78">
                  <c:v>8.0340000000000007</c:v>
                </c:pt>
                <c:pt idx="79">
                  <c:v>8.1370000000000005</c:v>
                </c:pt>
                <c:pt idx="80">
                  <c:v>8.24</c:v>
                </c:pt>
                <c:pt idx="81">
                  <c:v>8.343</c:v>
                </c:pt>
                <c:pt idx="82">
                  <c:v>8.4459999999999997</c:v>
                </c:pt>
                <c:pt idx="83">
                  <c:v>8.5489999999999995</c:v>
                </c:pt>
                <c:pt idx="84">
                  <c:v>8.6519999999999992</c:v>
                </c:pt>
                <c:pt idx="85">
                  <c:v>8.7550000000000008</c:v>
                </c:pt>
                <c:pt idx="86">
                  <c:v>8.8580000000000005</c:v>
                </c:pt>
                <c:pt idx="87">
                  <c:v>8.9610000000000003</c:v>
                </c:pt>
                <c:pt idx="88">
                  <c:v>9.0640000000000001</c:v>
                </c:pt>
                <c:pt idx="89">
                  <c:v>9.1669999999999998</c:v>
                </c:pt>
                <c:pt idx="90">
                  <c:v>9.27</c:v>
                </c:pt>
                <c:pt idx="91">
                  <c:v>9.3729999999999993</c:v>
                </c:pt>
                <c:pt idx="92">
                  <c:v>9.4760000000000009</c:v>
                </c:pt>
                <c:pt idx="93">
                  <c:v>9.5790000000000006</c:v>
                </c:pt>
                <c:pt idx="94">
                  <c:v>9.6820000000000004</c:v>
                </c:pt>
                <c:pt idx="95">
                  <c:v>9.7850000000000001</c:v>
                </c:pt>
                <c:pt idx="96">
                  <c:v>9.8879999999999999</c:v>
                </c:pt>
                <c:pt idx="97">
                  <c:v>9.9909999999999997</c:v>
                </c:pt>
                <c:pt idx="98">
                  <c:v>10.093999999999999</c:v>
                </c:pt>
                <c:pt idx="99">
                  <c:v>10.196999999999999</c:v>
                </c:pt>
                <c:pt idx="100">
                  <c:v>10.3</c:v>
                </c:pt>
                <c:pt idx="101">
                  <c:v>10.403</c:v>
                </c:pt>
                <c:pt idx="102">
                  <c:v>10.506</c:v>
                </c:pt>
                <c:pt idx="103">
                  <c:v>10.609</c:v>
                </c:pt>
                <c:pt idx="104">
                  <c:v>10.712</c:v>
                </c:pt>
                <c:pt idx="105">
                  <c:v>10.815</c:v>
                </c:pt>
                <c:pt idx="106">
                  <c:v>10.917999999999999</c:v>
                </c:pt>
                <c:pt idx="107">
                  <c:v>11.021000000000001</c:v>
                </c:pt>
                <c:pt idx="108">
                  <c:v>11.124000000000001</c:v>
                </c:pt>
                <c:pt idx="109">
                  <c:v>11.227</c:v>
                </c:pt>
                <c:pt idx="110">
                  <c:v>11.33</c:v>
                </c:pt>
                <c:pt idx="111">
                  <c:v>11.433</c:v>
                </c:pt>
                <c:pt idx="112">
                  <c:v>11.536</c:v>
                </c:pt>
                <c:pt idx="113">
                  <c:v>11.638999999999999</c:v>
                </c:pt>
                <c:pt idx="114">
                  <c:v>11.742000000000001</c:v>
                </c:pt>
                <c:pt idx="115">
                  <c:v>11.845000000000001</c:v>
                </c:pt>
                <c:pt idx="116">
                  <c:v>11.948</c:v>
                </c:pt>
                <c:pt idx="117">
                  <c:v>12.051</c:v>
                </c:pt>
                <c:pt idx="118">
                  <c:v>12.154</c:v>
                </c:pt>
                <c:pt idx="119">
                  <c:v>12.257</c:v>
                </c:pt>
                <c:pt idx="120">
                  <c:v>12.36</c:v>
                </c:pt>
                <c:pt idx="121">
                  <c:v>12.462999999999999</c:v>
                </c:pt>
                <c:pt idx="122">
                  <c:v>12.566000000000001</c:v>
                </c:pt>
                <c:pt idx="123">
                  <c:v>12.669</c:v>
                </c:pt>
                <c:pt idx="124">
                  <c:v>12.772</c:v>
                </c:pt>
                <c:pt idx="125">
                  <c:v>12.875</c:v>
                </c:pt>
                <c:pt idx="126">
                  <c:v>12.978</c:v>
                </c:pt>
                <c:pt idx="127">
                  <c:v>13.081</c:v>
                </c:pt>
                <c:pt idx="128">
                  <c:v>13.183999999999999</c:v>
                </c:pt>
                <c:pt idx="129">
                  <c:v>13.287000000000001</c:v>
                </c:pt>
                <c:pt idx="130">
                  <c:v>13.39</c:v>
                </c:pt>
                <c:pt idx="131">
                  <c:v>13.493</c:v>
                </c:pt>
                <c:pt idx="132">
                  <c:v>13.596</c:v>
                </c:pt>
                <c:pt idx="133">
                  <c:v>13.699</c:v>
                </c:pt>
                <c:pt idx="134">
                  <c:v>13.802</c:v>
                </c:pt>
                <c:pt idx="135">
                  <c:v>13.904999999999999</c:v>
                </c:pt>
                <c:pt idx="136">
                  <c:v>14.007999999999999</c:v>
                </c:pt>
                <c:pt idx="137">
                  <c:v>14.111000000000001</c:v>
                </c:pt>
                <c:pt idx="138">
                  <c:v>14.214</c:v>
                </c:pt>
                <c:pt idx="139">
                  <c:v>14.317</c:v>
                </c:pt>
                <c:pt idx="140">
                  <c:v>14.42</c:v>
                </c:pt>
                <c:pt idx="141">
                  <c:v>14.523</c:v>
                </c:pt>
                <c:pt idx="142">
                  <c:v>14.625999999999999</c:v>
                </c:pt>
                <c:pt idx="143">
                  <c:v>14.728999999999999</c:v>
                </c:pt>
                <c:pt idx="144">
                  <c:v>14.832000000000001</c:v>
                </c:pt>
                <c:pt idx="145">
                  <c:v>14.935</c:v>
                </c:pt>
                <c:pt idx="146">
                  <c:v>15.038</c:v>
                </c:pt>
                <c:pt idx="147">
                  <c:v>15.141</c:v>
                </c:pt>
                <c:pt idx="148">
                  <c:v>15.244</c:v>
                </c:pt>
                <c:pt idx="149">
                  <c:v>15.347</c:v>
                </c:pt>
                <c:pt idx="150">
                  <c:v>15.45</c:v>
                </c:pt>
                <c:pt idx="151">
                  <c:v>15.553000000000001</c:v>
                </c:pt>
                <c:pt idx="152">
                  <c:v>15.656000000000001</c:v>
                </c:pt>
                <c:pt idx="153">
                  <c:v>15.759</c:v>
                </c:pt>
                <c:pt idx="154">
                  <c:v>15.862</c:v>
                </c:pt>
                <c:pt idx="155">
                  <c:v>15.965</c:v>
                </c:pt>
                <c:pt idx="156">
                  <c:v>16.068000000000001</c:v>
                </c:pt>
                <c:pt idx="157">
                  <c:v>16.170999999999999</c:v>
                </c:pt>
                <c:pt idx="158">
                  <c:v>16.274000000000001</c:v>
                </c:pt>
                <c:pt idx="159">
                  <c:v>16.376999999999999</c:v>
                </c:pt>
                <c:pt idx="160">
                  <c:v>16.48</c:v>
                </c:pt>
                <c:pt idx="161">
                  <c:v>16.582999999999998</c:v>
                </c:pt>
                <c:pt idx="162">
                  <c:v>16.686</c:v>
                </c:pt>
                <c:pt idx="163">
                  <c:v>16.789000000000001</c:v>
                </c:pt>
                <c:pt idx="164">
                  <c:v>16.891999999999999</c:v>
                </c:pt>
                <c:pt idx="165">
                  <c:v>16.995000000000001</c:v>
                </c:pt>
                <c:pt idx="166">
                  <c:v>17.097999999999999</c:v>
                </c:pt>
                <c:pt idx="167">
                  <c:v>17.201000000000001</c:v>
                </c:pt>
                <c:pt idx="168">
                  <c:v>17.303999999999998</c:v>
                </c:pt>
                <c:pt idx="169">
                  <c:v>17.407</c:v>
                </c:pt>
                <c:pt idx="170">
                  <c:v>17.510000000000002</c:v>
                </c:pt>
                <c:pt idx="171">
                  <c:v>17.613</c:v>
                </c:pt>
                <c:pt idx="172">
                  <c:v>17.716000000000001</c:v>
                </c:pt>
                <c:pt idx="173">
                  <c:v>17.818999999999999</c:v>
                </c:pt>
                <c:pt idx="174">
                  <c:v>17.922000000000001</c:v>
                </c:pt>
                <c:pt idx="175">
                  <c:v>18.024999999999999</c:v>
                </c:pt>
                <c:pt idx="176">
                  <c:v>18.128</c:v>
                </c:pt>
                <c:pt idx="177">
                  <c:v>18.231000000000002</c:v>
                </c:pt>
                <c:pt idx="178">
                  <c:v>18.334</c:v>
                </c:pt>
                <c:pt idx="179">
                  <c:v>18.437000000000001</c:v>
                </c:pt>
                <c:pt idx="180">
                  <c:v>18.54</c:v>
                </c:pt>
                <c:pt idx="181">
                  <c:v>18.643000000000001</c:v>
                </c:pt>
                <c:pt idx="182">
                  <c:v>18.745999999999999</c:v>
                </c:pt>
                <c:pt idx="183">
                  <c:v>18.849</c:v>
                </c:pt>
                <c:pt idx="184">
                  <c:v>18.952000000000002</c:v>
                </c:pt>
                <c:pt idx="185">
                  <c:v>19.055</c:v>
                </c:pt>
                <c:pt idx="186">
                  <c:v>19.158000000000001</c:v>
                </c:pt>
                <c:pt idx="187">
                  <c:v>19.260999999999999</c:v>
                </c:pt>
                <c:pt idx="188">
                  <c:v>19.364000000000001</c:v>
                </c:pt>
                <c:pt idx="189">
                  <c:v>19.466999999999999</c:v>
                </c:pt>
              </c:numCache>
            </c:numRef>
          </c:xVal>
          <c:yVal>
            <c:numRef>
              <c:f>'imagen 26  perfil'!$B$2:$B$191</c:f>
              <c:numCache>
                <c:formatCode>General</c:formatCode>
                <c:ptCount val="190"/>
                <c:pt idx="0">
                  <c:v>55.677999999999997</c:v>
                </c:pt>
                <c:pt idx="1">
                  <c:v>55.382599999999996</c:v>
                </c:pt>
                <c:pt idx="2">
                  <c:v>54.609499999999997</c:v>
                </c:pt>
                <c:pt idx="3">
                  <c:v>50.528399999999998</c:v>
                </c:pt>
                <c:pt idx="4">
                  <c:v>57.953600000000002</c:v>
                </c:pt>
                <c:pt idx="5">
                  <c:v>58.722099999999998</c:v>
                </c:pt>
                <c:pt idx="6">
                  <c:v>62.757800000000003</c:v>
                </c:pt>
                <c:pt idx="7">
                  <c:v>67.935599999999994</c:v>
                </c:pt>
                <c:pt idx="8">
                  <c:v>69.279200000000003</c:v>
                </c:pt>
                <c:pt idx="9">
                  <c:v>71.164699999999996</c:v>
                </c:pt>
                <c:pt idx="10">
                  <c:v>63.975700000000003</c:v>
                </c:pt>
                <c:pt idx="11">
                  <c:v>70.949200000000005</c:v>
                </c:pt>
                <c:pt idx="12">
                  <c:v>60.302700000000002</c:v>
                </c:pt>
                <c:pt idx="13">
                  <c:v>55.565100000000001</c:v>
                </c:pt>
                <c:pt idx="14">
                  <c:v>49.920299999999997</c:v>
                </c:pt>
                <c:pt idx="15">
                  <c:v>48.962899999999998</c:v>
                </c:pt>
                <c:pt idx="16">
                  <c:v>46.153700000000001</c:v>
                </c:pt>
                <c:pt idx="17">
                  <c:v>47.0625</c:v>
                </c:pt>
                <c:pt idx="18">
                  <c:v>43.887599999999999</c:v>
                </c:pt>
                <c:pt idx="19">
                  <c:v>37.164499999999997</c:v>
                </c:pt>
                <c:pt idx="20">
                  <c:v>44.605699999999999</c:v>
                </c:pt>
                <c:pt idx="21">
                  <c:v>48.099699999999999</c:v>
                </c:pt>
                <c:pt idx="22">
                  <c:v>43.941499999999998</c:v>
                </c:pt>
                <c:pt idx="23">
                  <c:v>37.8748</c:v>
                </c:pt>
                <c:pt idx="24">
                  <c:v>44.021000000000001</c:v>
                </c:pt>
                <c:pt idx="25">
                  <c:v>34.351999999999997</c:v>
                </c:pt>
                <c:pt idx="26">
                  <c:v>33.2164</c:v>
                </c:pt>
                <c:pt idx="27">
                  <c:v>33.771099999999997</c:v>
                </c:pt>
                <c:pt idx="28">
                  <c:v>36.3172</c:v>
                </c:pt>
                <c:pt idx="29">
                  <c:v>35.616799999999998</c:v>
                </c:pt>
                <c:pt idx="30">
                  <c:v>33.479199999999999</c:v>
                </c:pt>
                <c:pt idx="31">
                  <c:v>27.614599999999999</c:v>
                </c:pt>
                <c:pt idx="32">
                  <c:v>27.124099999999999</c:v>
                </c:pt>
                <c:pt idx="33">
                  <c:v>30.196300000000001</c:v>
                </c:pt>
                <c:pt idx="34">
                  <c:v>33.0428</c:v>
                </c:pt>
                <c:pt idx="35">
                  <c:v>26.238099999999999</c:v>
                </c:pt>
                <c:pt idx="36">
                  <c:v>35.364699999999999</c:v>
                </c:pt>
                <c:pt idx="37">
                  <c:v>39.418999999999997</c:v>
                </c:pt>
                <c:pt idx="38">
                  <c:v>38.554099999999998</c:v>
                </c:pt>
                <c:pt idx="39">
                  <c:v>28.494599999999998</c:v>
                </c:pt>
                <c:pt idx="40">
                  <c:v>31.319900000000001</c:v>
                </c:pt>
                <c:pt idx="41">
                  <c:v>28.168700000000001</c:v>
                </c:pt>
                <c:pt idx="42">
                  <c:v>30.736899999999999</c:v>
                </c:pt>
                <c:pt idx="43">
                  <c:v>29.669599999999999</c:v>
                </c:pt>
                <c:pt idx="44">
                  <c:v>31.546900000000001</c:v>
                </c:pt>
                <c:pt idx="45">
                  <c:v>33.901699999999998</c:v>
                </c:pt>
                <c:pt idx="46">
                  <c:v>29.347799999999999</c:v>
                </c:pt>
                <c:pt idx="47">
                  <c:v>36.304400000000001</c:v>
                </c:pt>
                <c:pt idx="48">
                  <c:v>31.271599999999999</c:v>
                </c:pt>
                <c:pt idx="49">
                  <c:v>34.616799999999998</c:v>
                </c:pt>
                <c:pt idx="50">
                  <c:v>41.369</c:v>
                </c:pt>
                <c:pt idx="51">
                  <c:v>41.787199999999999</c:v>
                </c:pt>
                <c:pt idx="52">
                  <c:v>36.489400000000003</c:v>
                </c:pt>
                <c:pt idx="53">
                  <c:v>34.318100000000001</c:v>
                </c:pt>
                <c:pt idx="54">
                  <c:v>31.388300000000001</c:v>
                </c:pt>
                <c:pt idx="55">
                  <c:v>30.352599999999999</c:v>
                </c:pt>
                <c:pt idx="56">
                  <c:v>33.382399999999997</c:v>
                </c:pt>
                <c:pt idx="57">
                  <c:v>35.595599999999997</c:v>
                </c:pt>
                <c:pt idx="58">
                  <c:v>40.886899999999997</c:v>
                </c:pt>
                <c:pt idx="59">
                  <c:v>39.986699999999999</c:v>
                </c:pt>
                <c:pt idx="60">
                  <c:v>34.462899999999998</c:v>
                </c:pt>
                <c:pt idx="61">
                  <c:v>36.363799999999998</c:v>
                </c:pt>
                <c:pt idx="62">
                  <c:v>34.665199999999999</c:v>
                </c:pt>
                <c:pt idx="63">
                  <c:v>38.985700000000001</c:v>
                </c:pt>
                <c:pt idx="64">
                  <c:v>46.49</c:v>
                </c:pt>
                <c:pt idx="65">
                  <c:v>43.876100000000001</c:v>
                </c:pt>
                <c:pt idx="66">
                  <c:v>47.142000000000003</c:v>
                </c:pt>
                <c:pt idx="67">
                  <c:v>45.126100000000001</c:v>
                </c:pt>
                <c:pt idx="68">
                  <c:v>39.663699999999999</c:v>
                </c:pt>
                <c:pt idx="69">
                  <c:v>35.113100000000003</c:v>
                </c:pt>
                <c:pt idx="70">
                  <c:v>49.621600000000001</c:v>
                </c:pt>
                <c:pt idx="71">
                  <c:v>52.201999999999998</c:v>
                </c:pt>
                <c:pt idx="72">
                  <c:v>33.534100000000002</c:v>
                </c:pt>
                <c:pt idx="73">
                  <c:v>33.523699999999998</c:v>
                </c:pt>
                <c:pt idx="74">
                  <c:v>32.375500000000002</c:v>
                </c:pt>
                <c:pt idx="75">
                  <c:v>38.713999999999999</c:v>
                </c:pt>
                <c:pt idx="76">
                  <c:v>36.749699999999997</c:v>
                </c:pt>
                <c:pt idx="77">
                  <c:v>32.371400000000001</c:v>
                </c:pt>
                <c:pt idx="78">
                  <c:v>33.098599999999998</c:v>
                </c:pt>
                <c:pt idx="79">
                  <c:v>37.174700000000001</c:v>
                </c:pt>
                <c:pt idx="80">
                  <c:v>44.057899999999997</c:v>
                </c:pt>
                <c:pt idx="81">
                  <c:v>43.741500000000002</c:v>
                </c:pt>
                <c:pt idx="82">
                  <c:v>49.575600000000001</c:v>
                </c:pt>
                <c:pt idx="83">
                  <c:v>52.268000000000001</c:v>
                </c:pt>
                <c:pt idx="84">
                  <c:v>51.618000000000002</c:v>
                </c:pt>
                <c:pt idx="85">
                  <c:v>43.733199999999997</c:v>
                </c:pt>
                <c:pt idx="86">
                  <c:v>52.309699999999999</c:v>
                </c:pt>
                <c:pt idx="87">
                  <c:v>49.859000000000002</c:v>
                </c:pt>
                <c:pt idx="88">
                  <c:v>53.592100000000002</c:v>
                </c:pt>
                <c:pt idx="89">
                  <c:v>60.808900000000001</c:v>
                </c:pt>
                <c:pt idx="90">
                  <c:v>66.299199999999999</c:v>
                </c:pt>
                <c:pt idx="91">
                  <c:v>55.689</c:v>
                </c:pt>
                <c:pt idx="92">
                  <c:v>45.247900000000001</c:v>
                </c:pt>
                <c:pt idx="93">
                  <c:v>37.991599999999998</c:v>
                </c:pt>
                <c:pt idx="94">
                  <c:v>45.03</c:v>
                </c:pt>
                <c:pt idx="95">
                  <c:v>50.312399999999997</c:v>
                </c:pt>
                <c:pt idx="96">
                  <c:v>47.068899999999999</c:v>
                </c:pt>
                <c:pt idx="97">
                  <c:v>47.395699999999998</c:v>
                </c:pt>
                <c:pt idx="98">
                  <c:v>55.582000000000001</c:v>
                </c:pt>
                <c:pt idx="99">
                  <c:v>56.591299999999997</c:v>
                </c:pt>
                <c:pt idx="100">
                  <c:v>53.890599999999999</c:v>
                </c:pt>
                <c:pt idx="101">
                  <c:v>52.2042</c:v>
                </c:pt>
                <c:pt idx="102">
                  <c:v>51.045099999999998</c:v>
                </c:pt>
                <c:pt idx="103">
                  <c:v>56.431100000000001</c:v>
                </c:pt>
                <c:pt idx="104">
                  <c:v>56.227699999999999</c:v>
                </c:pt>
                <c:pt idx="105">
                  <c:v>54.978299999999997</c:v>
                </c:pt>
                <c:pt idx="106">
                  <c:v>50.619100000000003</c:v>
                </c:pt>
                <c:pt idx="107">
                  <c:v>55.867899999999999</c:v>
                </c:pt>
                <c:pt idx="108">
                  <c:v>54.421799999999998</c:v>
                </c:pt>
                <c:pt idx="109">
                  <c:v>44.3718</c:v>
                </c:pt>
                <c:pt idx="110">
                  <c:v>33.998100000000001</c:v>
                </c:pt>
                <c:pt idx="111">
                  <c:v>31.999700000000001</c:v>
                </c:pt>
                <c:pt idx="112">
                  <c:v>23.319600000000001</c:v>
                </c:pt>
                <c:pt idx="113">
                  <c:v>28.804300000000001</c:v>
                </c:pt>
                <c:pt idx="114">
                  <c:v>28.139800000000001</c:v>
                </c:pt>
                <c:pt idx="115">
                  <c:v>29.001799999999999</c:v>
                </c:pt>
                <c:pt idx="116">
                  <c:v>36.7515</c:v>
                </c:pt>
                <c:pt idx="117">
                  <c:v>37.783499999999997</c:v>
                </c:pt>
                <c:pt idx="118">
                  <c:v>27.336400000000001</c:v>
                </c:pt>
                <c:pt idx="119">
                  <c:v>30.1645</c:v>
                </c:pt>
                <c:pt idx="120">
                  <c:v>25.904800000000002</c:v>
                </c:pt>
                <c:pt idx="121">
                  <c:v>29.001100000000001</c:v>
                </c:pt>
                <c:pt idx="122">
                  <c:v>34.442</c:v>
                </c:pt>
                <c:pt idx="123">
                  <c:v>35.279000000000003</c:v>
                </c:pt>
                <c:pt idx="124">
                  <c:v>27.4831</c:v>
                </c:pt>
                <c:pt idx="125">
                  <c:v>25.676100000000002</c:v>
                </c:pt>
                <c:pt idx="126">
                  <c:v>28.929500000000001</c:v>
                </c:pt>
                <c:pt idx="127">
                  <c:v>29.921299999999999</c:v>
                </c:pt>
                <c:pt idx="128">
                  <c:v>24.5564</c:v>
                </c:pt>
                <c:pt idx="129">
                  <c:v>25.083200000000001</c:v>
                </c:pt>
                <c:pt idx="130">
                  <c:v>35.170699999999997</c:v>
                </c:pt>
                <c:pt idx="131">
                  <c:v>29.067499999999999</c:v>
                </c:pt>
                <c:pt idx="132">
                  <c:v>35.800400000000003</c:v>
                </c:pt>
                <c:pt idx="133">
                  <c:v>26.684000000000001</c:v>
                </c:pt>
                <c:pt idx="134">
                  <c:v>25.665299999999998</c:v>
                </c:pt>
                <c:pt idx="135">
                  <c:v>21.905100000000001</c:v>
                </c:pt>
                <c:pt idx="136">
                  <c:v>25.4832</c:v>
                </c:pt>
                <c:pt idx="137">
                  <c:v>31.6447</c:v>
                </c:pt>
                <c:pt idx="138">
                  <c:v>29.851199999999999</c:v>
                </c:pt>
                <c:pt idx="139">
                  <c:v>28.146699999999999</c:v>
                </c:pt>
                <c:pt idx="140">
                  <c:v>26.4099</c:v>
                </c:pt>
                <c:pt idx="141">
                  <c:v>27.290600000000001</c:v>
                </c:pt>
                <c:pt idx="142">
                  <c:v>30.640999999999998</c:v>
                </c:pt>
                <c:pt idx="143">
                  <c:v>27.691099999999999</c:v>
                </c:pt>
                <c:pt idx="144">
                  <c:v>28.7989</c:v>
                </c:pt>
                <c:pt idx="145">
                  <c:v>32.189300000000003</c:v>
                </c:pt>
                <c:pt idx="146">
                  <c:v>25.7865</c:v>
                </c:pt>
                <c:pt idx="147">
                  <c:v>37.687100000000001</c:v>
                </c:pt>
                <c:pt idx="148">
                  <c:v>26.8123</c:v>
                </c:pt>
                <c:pt idx="149">
                  <c:v>32.209699999999998</c:v>
                </c:pt>
                <c:pt idx="150">
                  <c:v>28.6309</c:v>
                </c:pt>
                <c:pt idx="151">
                  <c:v>24.837700000000002</c:v>
                </c:pt>
                <c:pt idx="152">
                  <c:v>36.1937</c:v>
                </c:pt>
                <c:pt idx="153">
                  <c:v>29.788499999999999</c:v>
                </c:pt>
                <c:pt idx="154">
                  <c:v>32.676299999999998</c:v>
                </c:pt>
                <c:pt idx="155">
                  <c:v>27.671099999999999</c:v>
                </c:pt>
                <c:pt idx="156">
                  <c:v>35.863</c:v>
                </c:pt>
                <c:pt idx="157">
                  <c:v>26.803000000000001</c:v>
                </c:pt>
                <c:pt idx="158">
                  <c:v>30.1797</c:v>
                </c:pt>
                <c:pt idx="159">
                  <c:v>26.8232</c:v>
                </c:pt>
                <c:pt idx="160">
                  <c:v>27.918199999999999</c:v>
                </c:pt>
                <c:pt idx="161">
                  <c:v>34.979999999999997</c:v>
                </c:pt>
                <c:pt idx="162">
                  <c:v>31.853899999999999</c:v>
                </c:pt>
                <c:pt idx="163">
                  <c:v>33.702199999999998</c:v>
                </c:pt>
                <c:pt idx="164">
                  <c:v>31.340399999999999</c:v>
                </c:pt>
                <c:pt idx="165">
                  <c:v>27.510200000000001</c:v>
                </c:pt>
                <c:pt idx="166">
                  <c:v>30.3109</c:v>
                </c:pt>
                <c:pt idx="167">
                  <c:v>31.260100000000001</c:v>
                </c:pt>
                <c:pt idx="168">
                  <c:v>32.232799999999997</c:v>
                </c:pt>
                <c:pt idx="169">
                  <c:v>35.559100000000001</c:v>
                </c:pt>
                <c:pt idx="170">
                  <c:v>34.050800000000002</c:v>
                </c:pt>
                <c:pt idx="171">
                  <c:v>40.369900000000001</c:v>
                </c:pt>
                <c:pt idx="172">
                  <c:v>35.1843</c:v>
                </c:pt>
                <c:pt idx="173">
                  <c:v>38.956299999999999</c:v>
                </c:pt>
                <c:pt idx="174">
                  <c:v>38.866799999999998</c:v>
                </c:pt>
                <c:pt idx="175">
                  <c:v>39.287100000000002</c:v>
                </c:pt>
                <c:pt idx="176">
                  <c:v>52.462000000000003</c:v>
                </c:pt>
                <c:pt idx="177">
                  <c:v>40.514099999999999</c:v>
                </c:pt>
                <c:pt idx="178">
                  <c:v>46.253300000000003</c:v>
                </c:pt>
                <c:pt idx="179">
                  <c:v>50.210900000000002</c:v>
                </c:pt>
                <c:pt idx="180">
                  <c:v>64.951999999999998</c:v>
                </c:pt>
                <c:pt idx="181">
                  <c:v>71.858999999999995</c:v>
                </c:pt>
                <c:pt idx="182">
                  <c:v>62.569000000000003</c:v>
                </c:pt>
                <c:pt idx="183">
                  <c:v>61.682699999999997</c:v>
                </c:pt>
                <c:pt idx="184">
                  <c:v>82.066400000000002</c:v>
                </c:pt>
                <c:pt idx="185">
                  <c:v>66.610799999999998</c:v>
                </c:pt>
                <c:pt idx="186">
                  <c:v>65.171800000000005</c:v>
                </c:pt>
                <c:pt idx="187">
                  <c:v>56.860999999999997</c:v>
                </c:pt>
                <c:pt idx="188">
                  <c:v>52.766399999999997</c:v>
                </c:pt>
                <c:pt idx="189">
                  <c:v>59.7096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D6C-4657-9433-1EF19D1D0C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6611423"/>
        <c:axId val="1866607679"/>
      </c:scatterChart>
      <c:valAx>
        <c:axId val="1866611423"/>
        <c:scaling>
          <c:orientation val="minMax"/>
          <c:max val="2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Distance (</a:t>
                </a:r>
                <a:r>
                  <a:rPr lang="el-GR" sz="1600"/>
                  <a:t>μ</a:t>
                </a:r>
                <a:r>
                  <a:rPr lang="en-US" sz="1600"/>
                  <a:t>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1866607679"/>
        <c:crosses val="autoZero"/>
        <c:crossBetween val="midCat"/>
      </c:valAx>
      <c:valAx>
        <c:axId val="1866607679"/>
        <c:scaling>
          <c:orientation val="minMax"/>
          <c:max val="90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Fluorescence</a:t>
                </a:r>
                <a:r>
                  <a:rPr lang="en-US" sz="1600" baseline="0"/>
                  <a:t> intensity (a.u.)</a:t>
                </a:r>
                <a:endParaRPr lang="en-US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1866611423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A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'imagen 33 perfil'!$B$1</c:f>
              <c:strCache>
                <c:ptCount val="1"/>
                <c:pt idx="0">
                  <c:v>Gray_Value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'imagen 33 perfil'!$A$2:$A$163</c:f>
              <c:numCache>
                <c:formatCode>General</c:formatCode>
                <c:ptCount val="162"/>
                <c:pt idx="0">
                  <c:v>0</c:v>
                </c:pt>
                <c:pt idx="1">
                  <c:v>0.13200000000000001</c:v>
                </c:pt>
                <c:pt idx="2">
                  <c:v>0.26400000000000001</c:v>
                </c:pt>
                <c:pt idx="3">
                  <c:v>0.39600000000000002</c:v>
                </c:pt>
                <c:pt idx="4">
                  <c:v>0.52800000000000002</c:v>
                </c:pt>
                <c:pt idx="5">
                  <c:v>0.66</c:v>
                </c:pt>
                <c:pt idx="6">
                  <c:v>0.79200000000000004</c:v>
                </c:pt>
                <c:pt idx="7">
                  <c:v>0.92400000000000004</c:v>
                </c:pt>
                <c:pt idx="8">
                  <c:v>1.056</c:v>
                </c:pt>
                <c:pt idx="9">
                  <c:v>1.1879999999999999</c:v>
                </c:pt>
                <c:pt idx="10">
                  <c:v>1.32</c:v>
                </c:pt>
                <c:pt idx="11">
                  <c:v>1.452</c:v>
                </c:pt>
                <c:pt idx="12">
                  <c:v>1.5840000000000001</c:v>
                </c:pt>
                <c:pt idx="13">
                  <c:v>1.716</c:v>
                </c:pt>
                <c:pt idx="14">
                  <c:v>1.8480000000000001</c:v>
                </c:pt>
                <c:pt idx="15">
                  <c:v>1.98</c:v>
                </c:pt>
                <c:pt idx="16">
                  <c:v>2.1120000000000001</c:v>
                </c:pt>
                <c:pt idx="17">
                  <c:v>2.2440000000000002</c:v>
                </c:pt>
                <c:pt idx="18">
                  <c:v>2.3759999999999999</c:v>
                </c:pt>
                <c:pt idx="19">
                  <c:v>2.508</c:v>
                </c:pt>
                <c:pt idx="20">
                  <c:v>2.64</c:v>
                </c:pt>
                <c:pt idx="21">
                  <c:v>2.7719999999999998</c:v>
                </c:pt>
                <c:pt idx="22">
                  <c:v>2.9039999999999999</c:v>
                </c:pt>
                <c:pt idx="23">
                  <c:v>3.036</c:v>
                </c:pt>
                <c:pt idx="24">
                  <c:v>3.1680000000000001</c:v>
                </c:pt>
                <c:pt idx="25">
                  <c:v>3.3</c:v>
                </c:pt>
                <c:pt idx="26">
                  <c:v>3.4319999999999999</c:v>
                </c:pt>
                <c:pt idx="27">
                  <c:v>3.5640000000000001</c:v>
                </c:pt>
                <c:pt idx="28">
                  <c:v>3.6960000000000002</c:v>
                </c:pt>
                <c:pt idx="29">
                  <c:v>3.8279999999999998</c:v>
                </c:pt>
                <c:pt idx="30">
                  <c:v>3.96</c:v>
                </c:pt>
                <c:pt idx="31">
                  <c:v>4.0919999999999996</c:v>
                </c:pt>
                <c:pt idx="32">
                  <c:v>4.2240000000000002</c:v>
                </c:pt>
                <c:pt idx="33">
                  <c:v>4.3559999999999999</c:v>
                </c:pt>
                <c:pt idx="34">
                  <c:v>4.4880000000000004</c:v>
                </c:pt>
                <c:pt idx="35">
                  <c:v>4.62</c:v>
                </c:pt>
                <c:pt idx="36">
                  <c:v>4.7519999999999998</c:v>
                </c:pt>
                <c:pt idx="37">
                  <c:v>4.8840000000000003</c:v>
                </c:pt>
                <c:pt idx="38">
                  <c:v>5.016</c:v>
                </c:pt>
                <c:pt idx="39">
                  <c:v>5.1479999999999997</c:v>
                </c:pt>
                <c:pt idx="40">
                  <c:v>5.28</c:v>
                </c:pt>
                <c:pt idx="41">
                  <c:v>5.4119999999999999</c:v>
                </c:pt>
                <c:pt idx="42">
                  <c:v>5.5439999999999996</c:v>
                </c:pt>
                <c:pt idx="43">
                  <c:v>5.6760000000000002</c:v>
                </c:pt>
                <c:pt idx="44">
                  <c:v>5.8079999999999998</c:v>
                </c:pt>
                <c:pt idx="45">
                  <c:v>5.94</c:v>
                </c:pt>
                <c:pt idx="46">
                  <c:v>6.0720000000000001</c:v>
                </c:pt>
                <c:pt idx="47">
                  <c:v>6.2039999999999997</c:v>
                </c:pt>
                <c:pt idx="48">
                  <c:v>6.3360000000000003</c:v>
                </c:pt>
                <c:pt idx="49">
                  <c:v>6.468</c:v>
                </c:pt>
                <c:pt idx="50">
                  <c:v>6.6</c:v>
                </c:pt>
                <c:pt idx="51">
                  <c:v>6.7320000000000002</c:v>
                </c:pt>
                <c:pt idx="52">
                  <c:v>6.8639999999999999</c:v>
                </c:pt>
                <c:pt idx="53">
                  <c:v>6.9960000000000004</c:v>
                </c:pt>
                <c:pt idx="54">
                  <c:v>7.1280000000000001</c:v>
                </c:pt>
                <c:pt idx="55">
                  <c:v>7.26</c:v>
                </c:pt>
                <c:pt idx="56">
                  <c:v>7.3920000000000003</c:v>
                </c:pt>
                <c:pt idx="57">
                  <c:v>7.524</c:v>
                </c:pt>
                <c:pt idx="58">
                  <c:v>7.6559999999999997</c:v>
                </c:pt>
                <c:pt idx="59">
                  <c:v>7.7880000000000003</c:v>
                </c:pt>
                <c:pt idx="60">
                  <c:v>7.92</c:v>
                </c:pt>
                <c:pt idx="61">
                  <c:v>8.0519999999999996</c:v>
                </c:pt>
                <c:pt idx="62">
                  <c:v>8.1839999999999993</c:v>
                </c:pt>
                <c:pt idx="63">
                  <c:v>8.3160000000000007</c:v>
                </c:pt>
                <c:pt idx="64">
                  <c:v>8.4480000000000004</c:v>
                </c:pt>
                <c:pt idx="65">
                  <c:v>8.58</c:v>
                </c:pt>
                <c:pt idx="66">
                  <c:v>8.7119999999999997</c:v>
                </c:pt>
                <c:pt idx="67">
                  <c:v>8.8439999999999994</c:v>
                </c:pt>
                <c:pt idx="68">
                  <c:v>8.9760000000000009</c:v>
                </c:pt>
                <c:pt idx="69">
                  <c:v>9.1080000000000005</c:v>
                </c:pt>
                <c:pt idx="70">
                  <c:v>9.24</c:v>
                </c:pt>
                <c:pt idx="71">
                  <c:v>9.3719999999999999</c:v>
                </c:pt>
                <c:pt idx="72">
                  <c:v>9.5039999999999996</c:v>
                </c:pt>
                <c:pt idx="73">
                  <c:v>9.6359999999999992</c:v>
                </c:pt>
                <c:pt idx="74">
                  <c:v>9.7680000000000007</c:v>
                </c:pt>
                <c:pt idx="75">
                  <c:v>9.9</c:v>
                </c:pt>
                <c:pt idx="76">
                  <c:v>10.032</c:v>
                </c:pt>
                <c:pt idx="77">
                  <c:v>10.164</c:v>
                </c:pt>
                <c:pt idx="78">
                  <c:v>10.295999999999999</c:v>
                </c:pt>
                <c:pt idx="79">
                  <c:v>10.428000000000001</c:v>
                </c:pt>
                <c:pt idx="80">
                  <c:v>10.56</c:v>
                </c:pt>
                <c:pt idx="81">
                  <c:v>10.692</c:v>
                </c:pt>
                <c:pt idx="82">
                  <c:v>10.824</c:v>
                </c:pt>
                <c:pt idx="83">
                  <c:v>10.956</c:v>
                </c:pt>
                <c:pt idx="84">
                  <c:v>11.087999999999999</c:v>
                </c:pt>
                <c:pt idx="85">
                  <c:v>11.22</c:v>
                </c:pt>
                <c:pt idx="86">
                  <c:v>11.352</c:v>
                </c:pt>
                <c:pt idx="87">
                  <c:v>11.484</c:v>
                </c:pt>
                <c:pt idx="88">
                  <c:v>11.616</c:v>
                </c:pt>
                <c:pt idx="89">
                  <c:v>11.747999999999999</c:v>
                </c:pt>
                <c:pt idx="90">
                  <c:v>11.88</c:v>
                </c:pt>
                <c:pt idx="91">
                  <c:v>12.012</c:v>
                </c:pt>
                <c:pt idx="92">
                  <c:v>12.144</c:v>
                </c:pt>
                <c:pt idx="93">
                  <c:v>12.276</c:v>
                </c:pt>
                <c:pt idx="94">
                  <c:v>12.407999999999999</c:v>
                </c:pt>
                <c:pt idx="95">
                  <c:v>12.54</c:v>
                </c:pt>
                <c:pt idx="96">
                  <c:v>12.672000000000001</c:v>
                </c:pt>
                <c:pt idx="97">
                  <c:v>12.804</c:v>
                </c:pt>
                <c:pt idx="98">
                  <c:v>12.936</c:v>
                </c:pt>
                <c:pt idx="99">
                  <c:v>13.068</c:v>
                </c:pt>
                <c:pt idx="100">
                  <c:v>13.2</c:v>
                </c:pt>
                <c:pt idx="101">
                  <c:v>13.332000000000001</c:v>
                </c:pt>
                <c:pt idx="102">
                  <c:v>13.464</c:v>
                </c:pt>
                <c:pt idx="103">
                  <c:v>13.596</c:v>
                </c:pt>
                <c:pt idx="104">
                  <c:v>13.728</c:v>
                </c:pt>
                <c:pt idx="105">
                  <c:v>13.86</c:v>
                </c:pt>
                <c:pt idx="106">
                  <c:v>13.992000000000001</c:v>
                </c:pt>
                <c:pt idx="107">
                  <c:v>14.124000000000001</c:v>
                </c:pt>
                <c:pt idx="108">
                  <c:v>14.256</c:v>
                </c:pt>
                <c:pt idx="109">
                  <c:v>14.388</c:v>
                </c:pt>
                <c:pt idx="110">
                  <c:v>14.52</c:v>
                </c:pt>
                <c:pt idx="111">
                  <c:v>14.651999999999999</c:v>
                </c:pt>
                <c:pt idx="112">
                  <c:v>14.784000000000001</c:v>
                </c:pt>
                <c:pt idx="113">
                  <c:v>14.916</c:v>
                </c:pt>
                <c:pt idx="114">
                  <c:v>15.048</c:v>
                </c:pt>
                <c:pt idx="115">
                  <c:v>15.18</c:v>
                </c:pt>
                <c:pt idx="116">
                  <c:v>15.311999999999999</c:v>
                </c:pt>
                <c:pt idx="117">
                  <c:v>15.444000000000001</c:v>
                </c:pt>
                <c:pt idx="118">
                  <c:v>15.576000000000001</c:v>
                </c:pt>
                <c:pt idx="119">
                  <c:v>15.708</c:v>
                </c:pt>
                <c:pt idx="120">
                  <c:v>15.84</c:v>
                </c:pt>
                <c:pt idx="121">
                  <c:v>15.972</c:v>
                </c:pt>
                <c:pt idx="122">
                  <c:v>16.103999999999999</c:v>
                </c:pt>
                <c:pt idx="123">
                  <c:v>16.236000000000001</c:v>
                </c:pt>
                <c:pt idx="124">
                  <c:v>16.367999999999999</c:v>
                </c:pt>
                <c:pt idx="125">
                  <c:v>16.5</c:v>
                </c:pt>
                <c:pt idx="126">
                  <c:v>16.632000000000001</c:v>
                </c:pt>
                <c:pt idx="127">
                  <c:v>16.763999999999999</c:v>
                </c:pt>
                <c:pt idx="128">
                  <c:v>16.896000000000001</c:v>
                </c:pt>
                <c:pt idx="129">
                  <c:v>17.027999999999999</c:v>
                </c:pt>
                <c:pt idx="130">
                  <c:v>17.16</c:v>
                </c:pt>
                <c:pt idx="131">
                  <c:v>17.292000000000002</c:v>
                </c:pt>
                <c:pt idx="132">
                  <c:v>17.423999999999999</c:v>
                </c:pt>
                <c:pt idx="133">
                  <c:v>17.556000000000001</c:v>
                </c:pt>
                <c:pt idx="134">
                  <c:v>17.687999999999999</c:v>
                </c:pt>
                <c:pt idx="135">
                  <c:v>17.82</c:v>
                </c:pt>
                <c:pt idx="136">
                  <c:v>17.952000000000002</c:v>
                </c:pt>
                <c:pt idx="137">
                  <c:v>18.084</c:v>
                </c:pt>
                <c:pt idx="138">
                  <c:v>18.216000000000001</c:v>
                </c:pt>
                <c:pt idx="139">
                  <c:v>18.347999999999999</c:v>
                </c:pt>
                <c:pt idx="140">
                  <c:v>18.48</c:v>
                </c:pt>
                <c:pt idx="141">
                  <c:v>18.611999999999998</c:v>
                </c:pt>
                <c:pt idx="142">
                  <c:v>18.744</c:v>
                </c:pt>
                <c:pt idx="143">
                  <c:v>18.876000000000001</c:v>
                </c:pt>
                <c:pt idx="144">
                  <c:v>19.007999999999999</c:v>
                </c:pt>
                <c:pt idx="145">
                  <c:v>19.14</c:v>
                </c:pt>
                <c:pt idx="146">
                  <c:v>19.271999999999998</c:v>
                </c:pt>
                <c:pt idx="147">
                  <c:v>19.404</c:v>
                </c:pt>
                <c:pt idx="148">
                  <c:v>19.536000000000001</c:v>
                </c:pt>
                <c:pt idx="149">
                  <c:v>19.667999999999999</c:v>
                </c:pt>
                <c:pt idx="150">
                  <c:v>19.8</c:v>
                </c:pt>
                <c:pt idx="151">
                  <c:v>19.931999999999999</c:v>
                </c:pt>
                <c:pt idx="152">
                  <c:v>20.064</c:v>
                </c:pt>
                <c:pt idx="153">
                  <c:v>20.196000000000002</c:v>
                </c:pt>
                <c:pt idx="154">
                  <c:v>20.327999999999999</c:v>
                </c:pt>
                <c:pt idx="155">
                  <c:v>20.46</c:v>
                </c:pt>
                <c:pt idx="156">
                  <c:v>20.591999999999999</c:v>
                </c:pt>
                <c:pt idx="157">
                  <c:v>20.724</c:v>
                </c:pt>
                <c:pt idx="158">
                  <c:v>20.856000000000002</c:v>
                </c:pt>
                <c:pt idx="159">
                  <c:v>20.988</c:v>
                </c:pt>
                <c:pt idx="160">
                  <c:v>21.12</c:v>
                </c:pt>
                <c:pt idx="161">
                  <c:v>21.251999999999999</c:v>
                </c:pt>
              </c:numCache>
            </c:numRef>
          </c:xVal>
          <c:yVal>
            <c:numRef>
              <c:f>'imagen 33 perfil'!$B$2:$B$163</c:f>
              <c:numCache>
                <c:formatCode>General</c:formatCode>
                <c:ptCount val="162"/>
                <c:pt idx="0">
                  <c:v>144.98400000000001</c:v>
                </c:pt>
                <c:pt idx="1">
                  <c:v>156.096</c:v>
                </c:pt>
                <c:pt idx="2">
                  <c:v>149.53</c:v>
                </c:pt>
                <c:pt idx="3">
                  <c:v>166.03399999999999</c:v>
                </c:pt>
                <c:pt idx="4">
                  <c:v>170.541</c:v>
                </c:pt>
                <c:pt idx="5">
                  <c:v>176.32900000000001</c:v>
                </c:pt>
                <c:pt idx="6">
                  <c:v>178.988</c:v>
                </c:pt>
                <c:pt idx="7">
                  <c:v>179.608</c:v>
                </c:pt>
                <c:pt idx="8">
                  <c:v>169.68899999999999</c:v>
                </c:pt>
                <c:pt idx="9">
                  <c:v>152.928</c:v>
                </c:pt>
                <c:pt idx="10">
                  <c:v>111.755</c:v>
                </c:pt>
                <c:pt idx="11">
                  <c:v>101.384</c:v>
                </c:pt>
                <c:pt idx="12">
                  <c:v>93.156999999999996</c:v>
                </c:pt>
                <c:pt idx="13">
                  <c:v>89.622</c:v>
                </c:pt>
                <c:pt idx="14">
                  <c:v>86.494</c:v>
                </c:pt>
                <c:pt idx="15">
                  <c:v>88.843000000000004</c:v>
                </c:pt>
                <c:pt idx="16">
                  <c:v>72.757000000000005</c:v>
                </c:pt>
                <c:pt idx="17">
                  <c:v>73.378</c:v>
                </c:pt>
                <c:pt idx="18">
                  <c:v>73.61</c:v>
                </c:pt>
                <c:pt idx="19">
                  <c:v>73.343000000000004</c:v>
                </c:pt>
                <c:pt idx="20">
                  <c:v>88.765000000000001</c:v>
                </c:pt>
                <c:pt idx="21">
                  <c:v>80.462999999999994</c:v>
                </c:pt>
                <c:pt idx="22">
                  <c:v>84.119</c:v>
                </c:pt>
                <c:pt idx="23">
                  <c:v>79.08</c:v>
                </c:pt>
                <c:pt idx="24">
                  <c:v>83.966999999999999</c:v>
                </c:pt>
                <c:pt idx="25">
                  <c:v>73.712000000000003</c:v>
                </c:pt>
                <c:pt idx="26">
                  <c:v>68.429000000000002</c:v>
                </c:pt>
                <c:pt idx="27">
                  <c:v>77.747</c:v>
                </c:pt>
                <c:pt idx="28">
                  <c:v>89.902000000000001</c:v>
                </c:pt>
                <c:pt idx="29">
                  <c:v>97.010999999999996</c:v>
                </c:pt>
                <c:pt idx="30">
                  <c:v>91.39</c:v>
                </c:pt>
                <c:pt idx="31">
                  <c:v>90.138999999999996</c:v>
                </c:pt>
                <c:pt idx="32">
                  <c:v>90.165999999999997</c:v>
                </c:pt>
                <c:pt idx="33">
                  <c:v>90.116</c:v>
                </c:pt>
                <c:pt idx="34">
                  <c:v>91.332999999999998</c:v>
                </c:pt>
                <c:pt idx="35">
                  <c:v>99.218999999999994</c:v>
                </c:pt>
                <c:pt idx="36">
                  <c:v>82.793999999999997</c:v>
                </c:pt>
                <c:pt idx="37">
                  <c:v>79.286000000000001</c:v>
                </c:pt>
                <c:pt idx="38">
                  <c:v>79.289000000000001</c:v>
                </c:pt>
                <c:pt idx="39">
                  <c:v>73.965999999999994</c:v>
                </c:pt>
                <c:pt idx="40">
                  <c:v>86.960999999999999</c:v>
                </c:pt>
                <c:pt idx="41">
                  <c:v>86.224000000000004</c:v>
                </c:pt>
                <c:pt idx="42">
                  <c:v>71.001000000000005</c:v>
                </c:pt>
                <c:pt idx="43">
                  <c:v>80.067999999999998</c:v>
                </c:pt>
                <c:pt idx="44">
                  <c:v>78.613</c:v>
                </c:pt>
                <c:pt idx="45">
                  <c:v>72.674999999999997</c:v>
                </c:pt>
                <c:pt idx="46">
                  <c:v>72.149000000000001</c:v>
                </c:pt>
                <c:pt idx="47">
                  <c:v>72.504000000000005</c:v>
                </c:pt>
                <c:pt idx="48">
                  <c:v>75.204999999999998</c:v>
                </c:pt>
                <c:pt idx="49">
                  <c:v>76.894000000000005</c:v>
                </c:pt>
                <c:pt idx="50">
                  <c:v>71.820999999999998</c:v>
                </c:pt>
                <c:pt idx="51">
                  <c:v>75.673000000000002</c:v>
                </c:pt>
                <c:pt idx="52">
                  <c:v>66.721999999999994</c:v>
                </c:pt>
                <c:pt idx="53">
                  <c:v>70.927000000000007</c:v>
                </c:pt>
                <c:pt idx="54">
                  <c:v>85.885999999999996</c:v>
                </c:pt>
                <c:pt idx="55">
                  <c:v>82.257999999999996</c:v>
                </c:pt>
                <c:pt idx="56">
                  <c:v>74.305999999999997</c:v>
                </c:pt>
                <c:pt idx="57">
                  <c:v>86.584000000000003</c:v>
                </c:pt>
                <c:pt idx="58">
                  <c:v>82.123999999999995</c:v>
                </c:pt>
                <c:pt idx="59">
                  <c:v>88.099000000000004</c:v>
                </c:pt>
                <c:pt idx="60">
                  <c:v>98.474999999999994</c:v>
                </c:pt>
                <c:pt idx="61">
                  <c:v>98.856999999999999</c:v>
                </c:pt>
                <c:pt idx="62">
                  <c:v>75.271000000000001</c:v>
                </c:pt>
                <c:pt idx="63">
                  <c:v>68.626999999999995</c:v>
                </c:pt>
                <c:pt idx="64">
                  <c:v>63.491</c:v>
                </c:pt>
                <c:pt idx="65">
                  <c:v>69.573999999999998</c:v>
                </c:pt>
                <c:pt idx="66">
                  <c:v>80.025000000000006</c:v>
                </c:pt>
                <c:pt idx="67">
                  <c:v>82.680999999999997</c:v>
                </c:pt>
                <c:pt idx="68">
                  <c:v>90.49</c:v>
                </c:pt>
                <c:pt idx="69">
                  <c:v>85.06</c:v>
                </c:pt>
                <c:pt idx="70">
                  <c:v>78.908000000000001</c:v>
                </c:pt>
                <c:pt idx="71">
                  <c:v>91.08</c:v>
                </c:pt>
                <c:pt idx="72">
                  <c:v>97.858000000000004</c:v>
                </c:pt>
                <c:pt idx="73">
                  <c:v>99.734999999999999</c:v>
                </c:pt>
                <c:pt idx="74">
                  <c:v>86.087999999999994</c:v>
                </c:pt>
                <c:pt idx="75">
                  <c:v>81.647999999999996</c:v>
                </c:pt>
                <c:pt idx="76">
                  <c:v>84.019000000000005</c:v>
                </c:pt>
                <c:pt idx="77">
                  <c:v>79.588999999999999</c:v>
                </c:pt>
                <c:pt idx="78">
                  <c:v>71.578000000000003</c:v>
                </c:pt>
                <c:pt idx="79">
                  <c:v>65.521000000000001</c:v>
                </c:pt>
                <c:pt idx="80">
                  <c:v>75.861999999999995</c:v>
                </c:pt>
                <c:pt idx="81">
                  <c:v>77.313999999999993</c:v>
                </c:pt>
                <c:pt idx="82">
                  <c:v>84.551000000000002</c:v>
                </c:pt>
                <c:pt idx="83">
                  <c:v>83.215999999999994</c:v>
                </c:pt>
                <c:pt idx="84">
                  <c:v>92.513999999999996</c:v>
                </c:pt>
                <c:pt idx="85">
                  <c:v>93.935000000000002</c:v>
                </c:pt>
                <c:pt idx="86">
                  <c:v>87.751999999999995</c:v>
                </c:pt>
                <c:pt idx="87">
                  <c:v>96.254000000000005</c:v>
                </c:pt>
                <c:pt idx="88">
                  <c:v>94.980999999999995</c:v>
                </c:pt>
                <c:pt idx="89">
                  <c:v>69.850999999999999</c:v>
                </c:pt>
                <c:pt idx="90">
                  <c:v>76.516999999999996</c:v>
                </c:pt>
                <c:pt idx="91">
                  <c:v>92.234999999999999</c:v>
                </c:pt>
                <c:pt idx="92">
                  <c:v>90.191000000000003</c:v>
                </c:pt>
                <c:pt idx="93">
                  <c:v>82.918000000000006</c:v>
                </c:pt>
                <c:pt idx="94">
                  <c:v>98.24</c:v>
                </c:pt>
                <c:pt idx="95">
                  <c:v>91.998999999999995</c:v>
                </c:pt>
                <c:pt idx="96">
                  <c:v>90.603999999999999</c:v>
                </c:pt>
                <c:pt idx="97">
                  <c:v>88.207999999999998</c:v>
                </c:pt>
                <c:pt idx="98">
                  <c:v>85.093999999999994</c:v>
                </c:pt>
                <c:pt idx="99">
                  <c:v>79.543000000000006</c:v>
                </c:pt>
                <c:pt idx="100">
                  <c:v>78.843999999999994</c:v>
                </c:pt>
                <c:pt idx="101">
                  <c:v>80.162999999999997</c:v>
                </c:pt>
                <c:pt idx="102">
                  <c:v>74.102999999999994</c:v>
                </c:pt>
                <c:pt idx="103">
                  <c:v>67.721999999999994</c:v>
                </c:pt>
                <c:pt idx="104">
                  <c:v>65.486999999999995</c:v>
                </c:pt>
                <c:pt idx="105">
                  <c:v>65.334000000000003</c:v>
                </c:pt>
                <c:pt idx="106">
                  <c:v>57.603000000000002</c:v>
                </c:pt>
                <c:pt idx="107">
                  <c:v>60.448999999999998</c:v>
                </c:pt>
                <c:pt idx="108">
                  <c:v>68.486000000000004</c:v>
                </c:pt>
                <c:pt idx="109">
                  <c:v>59.603000000000002</c:v>
                </c:pt>
                <c:pt idx="110">
                  <c:v>63.283000000000001</c:v>
                </c:pt>
                <c:pt idx="111">
                  <c:v>75.619</c:v>
                </c:pt>
                <c:pt idx="112">
                  <c:v>77.451999999999998</c:v>
                </c:pt>
                <c:pt idx="113">
                  <c:v>83.465999999999994</c:v>
                </c:pt>
                <c:pt idx="114">
                  <c:v>86.375</c:v>
                </c:pt>
                <c:pt idx="115">
                  <c:v>92.744</c:v>
                </c:pt>
                <c:pt idx="116">
                  <c:v>85.078000000000003</c:v>
                </c:pt>
                <c:pt idx="117">
                  <c:v>81.213999999999999</c:v>
                </c:pt>
                <c:pt idx="118">
                  <c:v>88.171999999999997</c:v>
                </c:pt>
                <c:pt idx="119">
                  <c:v>90.674000000000007</c:v>
                </c:pt>
                <c:pt idx="120">
                  <c:v>85.262</c:v>
                </c:pt>
                <c:pt idx="121">
                  <c:v>84.152000000000001</c:v>
                </c:pt>
                <c:pt idx="122">
                  <c:v>93.153000000000006</c:v>
                </c:pt>
                <c:pt idx="123">
                  <c:v>80.664000000000001</c:v>
                </c:pt>
                <c:pt idx="124">
                  <c:v>85.918000000000006</c:v>
                </c:pt>
                <c:pt idx="125">
                  <c:v>82.082999999999998</c:v>
                </c:pt>
                <c:pt idx="126">
                  <c:v>82.762</c:v>
                </c:pt>
                <c:pt idx="127">
                  <c:v>78.387</c:v>
                </c:pt>
                <c:pt idx="128">
                  <c:v>88.135999999999996</c:v>
                </c:pt>
                <c:pt idx="129">
                  <c:v>94.694000000000003</c:v>
                </c:pt>
                <c:pt idx="130">
                  <c:v>80.866</c:v>
                </c:pt>
                <c:pt idx="131">
                  <c:v>84.414000000000001</c:v>
                </c:pt>
                <c:pt idx="132">
                  <c:v>94.643000000000001</c:v>
                </c:pt>
                <c:pt idx="133">
                  <c:v>92.021000000000001</c:v>
                </c:pt>
                <c:pt idx="134">
                  <c:v>81.849000000000004</c:v>
                </c:pt>
                <c:pt idx="135">
                  <c:v>94.614000000000004</c:v>
                </c:pt>
                <c:pt idx="136">
                  <c:v>99.793999999999997</c:v>
                </c:pt>
                <c:pt idx="137">
                  <c:v>85.57</c:v>
                </c:pt>
                <c:pt idx="138">
                  <c:v>84.465999999999994</c:v>
                </c:pt>
                <c:pt idx="139">
                  <c:v>89.001000000000005</c:v>
                </c:pt>
                <c:pt idx="140">
                  <c:v>85.304000000000002</c:v>
                </c:pt>
                <c:pt idx="141">
                  <c:v>87.424000000000007</c:v>
                </c:pt>
                <c:pt idx="142">
                  <c:v>96.022999999999996</c:v>
                </c:pt>
                <c:pt idx="143">
                  <c:v>111.001</c:v>
                </c:pt>
                <c:pt idx="144">
                  <c:v>110.712</c:v>
                </c:pt>
                <c:pt idx="145">
                  <c:v>118.52800000000001</c:v>
                </c:pt>
                <c:pt idx="146">
                  <c:v>135.738</c:v>
                </c:pt>
                <c:pt idx="147">
                  <c:v>116.107</c:v>
                </c:pt>
                <c:pt idx="148">
                  <c:v>130.874</c:v>
                </c:pt>
                <c:pt idx="149">
                  <c:v>141.41200000000001</c:v>
                </c:pt>
                <c:pt idx="150">
                  <c:v>146.71799999999999</c:v>
                </c:pt>
                <c:pt idx="151">
                  <c:v>135.749</c:v>
                </c:pt>
                <c:pt idx="152">
                  <c:v>126.748</c:v>
                </c:pt>
                <c:pt idx="153">
                  <c:v>129.16399999999999</c:v>
                </c:pt>
                <c:pt idx="154">
                  <c:v>125.44499999999999</c:v>
                </c:pt>
                <c:pt idx="155">
                  <c:v>125.80200000000001</c:v>
                </c:pt>
                <c:pt idx="156">
                  <c:v>115.258</c:v>
                </c:pt>
                <c:pt idx="157">
                  <c:v>126.89</c:v>
                </c:pt>
                <c:pt idx="158">
                  <c:v>126.13800000000001</c:v>
                </c:pt>
                <c:pt idx="159">
                  <c:v>121.928</c:v>
                </c:pt>
                <c:pt idx="160">
                  <c:v>128.58500000000001</c:v>
                </c:pt>
                <c:pt idx="161">
                  <c:v>126.83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A2E-481D-97B9-E462E969DF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1876000"/>
        <c:axId val="831876832"/>
      </c:scatterChart>
      <c:valAx>
        <c:axId val="831876000"/>
        <c:scaling>
          <c:orientation val="minMax"/>
          <c:max val="23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Distance (</a:t>
                </a:r>
                <a:r>
                  <a:rPr lang="el-GR" sz="1600"/>
                  <a:t>μ</a:t>
                </a:r>
                <a:r>
                  <a:rPr lang="es-AR" sz="1600"/>
                  <a:t>m)</a:t>
                </a:r>
                <a:endParaRPr lang="en-US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831876832"/>
        <c:crosses val="autoZero"/>
        <c:crossBetween val="midCat"/>
      </c:valAx>
      <c:valAx>
        <c:axId val="831876832"/>
        <c:scaling>
          <c:orientation val="minMax"/>
          <c:max val="190"/>
          <c:min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Fluorescence intensity (a.u.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831876000"/>
        <c:crosses val="autoZero"/>
        <c:crossBetween val="midCat"/>
        <c:majorUnit val="4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A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'imagen 41 perfil'!$B$1</c:f>
              <c:strCache>
                <c:ptCount val="1"/>
                <c:pt idx="0">
                  <c:v>Gray_Value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'imagen 41 perfil'!$A$2:$A$136</c:f>
              <c:numCache>
                <c:formatCode>General</c:formatCode>
                <c:ptCount val="135"/>
                <c:pt idx="0">
                  <c:v>0</c:v>
                </c:pt>
                <c:pt idx="1">
                  <c:v>0.10299999999999999</c:v>
                </c:pt>
                <c:pt idx="2">
                  <c:v>0.20599999999999999</c:v>
                </c:pt>
                <c:pt idx="3">
                  <c:v>0.309</c:v>
                </c:pt>
                <c:pt idx="4">
                  <c:v>0.41199999999999998</c:v>
                </c:pt>
                <c:pt idx="5">
                  <c:v>0.51500000000000001</c:v>
                </c:pt>
                <c:pt idx="6">
                  <c:v>0.61799999999999999</c:v>
                </c:pt>
                <c:pt idx="7">
                  <c:v>0.72099999999999997</c:v>
                </c:pt>
                <c:pt idx="8">
                  <c:v>0.82399999999999995</c:v>
                </c:pt>
                <c:pt idx="9">
                  <c:v>0.92700000000000005</c:v>
                </c:pt>
                <c:pt idx="10">
                  <c:v>1.03</c:v>
                </c:pt>
                <c:pt idx="11">
                  <c:v>1.133</c:v>
                </c:pt>
                <c:pt idx="12">
                  <c:v>1.236</c:v>
                </c:pt>
                <c:pt idx="13">
                  <c:v>1.339</c:v>
                </c:pt>
                <c:pt idx="14">
                  <c:v>1.4419999999999999</c:v>
                </c:pt>
                <c:pt idx="15">
                  <c:v>1.5449999999999999</c:v>
                </c:pt>
                <c:pt idx="16">
                  <c:v>1.6479999999999999</c:v>
                </c:pt>
                <c:pt idx="17">
                  <c:v>1.7509999999999999</c:v>
                </c:pt>
                <c:pt idx="18">
                  <c:v>1.8540000000000001</c:v>
                </c:pt>
                <c:pt idx="19">
                  <c:v>1.9570000000000001</c:v>
                </c:pt>
                <c:pt idx="20">
                  <c:v>2.06</c:v>
                </c:pt>
                <c:pt idx="21">
                  <c:v>2.1629999999999998</c:v>
                </c:pt>
                <c:pt idx="22">
                  <c:v>2.266</c:v>
                </c:pt>
                <c:pt idx="23">
                  <c:v>2.3690000000000002</c:v>
                </c:pt>
                <c:pt idx="24">
                  <c:v>2.472</c:v>
                </c:pt>
                <c:pt idx="25">
                  <c:v>2.5750000000000002</c:v>
                </c:pt>
                <c:pt idx="26">
                  <c:v>2.6779999999999999</c:v>
                </c:pt>
                <c:pt idx="27">
                  <c:v>2.7810000000000001</c:v>
                </c:pt>
                <c:pt idx="28">
                  <c:v>2.8839999999999999</c:v>
                </c:pt>
                <c:pt idx="29">
                  <c:v>2.9870000000000001</c:v>
                </c:pt>
                <c:pt idx="30">
                  <c:v>3.09</c:v>
                </c:pt>
                <c:pt idx="31">
                  <c:v>3.1930000000000001</c:v>
                </c:pt>
                <c:pt idx="32">
                  <c:v>3.2959999999999998</c:v>
                </c:pt>
                <c:pt idx="33">
                  <c:v>3.399</c:v>
                </c:pt>
                <c:pt idx="34">
                  <c:v>3.5019999999999998</c:v>
                </c:pt>
                <c:pt idx="35">
                  <c:v>3.605</c:v>
                </c:pt>
                <c:pt idx="36">
                  <c:v>3.7080000000000002</c:v>
                </c:pt>
                <c:pt idx="37">
                  <c:v>3.8109999999999999</c:v>
                </c:pt>
                <c:pt idx="38">
                  <c:v>3.9140000000000001</c:v>
                </c:pt>
                <c:pt idx="39">
                  <c:v>4.0170000000000003</c:v>
                </c:pt>
                <c:pt idx="40">
                  <c:v>4.12</c:v>
                </c:pt>
                <c:pt idx="41">
                  <c:v>4.2229999999999999</c:v>
                </c:pt>
                <c:pt idx="42">
                  <c:v>4.3259999999999996</c:v>
                </c:pt>
                <c:pt idx="43">
                  <c:v>4.4290000000000003</c:v>
                </c:pt>
                <c:pt idx="44">
                  <c:v>4.532</c:v>
                </c:pt>
                <c:pt idx="45">
                  <c:v>4.6349999999999998</c:v>
                </c:pt>
                <c:pt idx="46">
                  <c:v>4.7380000000000004</c:v>
                </c:pt>
                <c:pt idx="47">
                  <c:v>4.8410000000000002</c:v>
                </c:pt>
                <c:pt idx="48">
                  <c:v>4.944</c:v>
                </c:pt>
                <c:pt idx="49">
                  <c:v>5.0469999999999997</c:v>
                </c:pt>
                <c:pt idx="50">
                  <c:v>5.15</c:v>
                </c:pt>
                <c:pt idx="51">
                  <c:v>5.2530000000000001</c:v>
                </c:pt>
                <c:pt idx="52">
                  <c:v>5.3559999999999999</c:v>
                </c:pt>
                <c:pt idx="53">
                  <c:v>5.4589999999999996</c:v>
                </c:pt>
                <c:pt idx="54">
                  <c:v>5.5620000000000003</c:v>
                </c:pt>
                <c:pt idx="55">
                  <c:v>5.665</c:v>
                </c:pt>
                <c:pt idx="56">
                  <c:v>5.7679999999999998</c:v>
                </c:pt>
                <c:pt idx="57">
                  <c:v>5.8710000000000004</c:v>
                </c:pt>
                <c:pt idx="58">
                  <c:v>5.9740000000000002</c:v>
                </c:pt>
                <c:pt idx="59">
                  <c:v>6.077</c:v>
                </c:pt>
                <c:pt idx="60">
                  <c:v>6.18</c:v>
                </c:pt>
                <c:pt idx="61">
                  <c:v>6.2830000000000004</c:v>
                </c:pt>
                <c:pt idx="62">
                  <c:v>6.3860000000000001</c:v>
                </c:pt>
                <c:pt idx="63">
                  <c:v>6.4889999999999999</c:v>
                </c:pt>
                <c:pt idx="64">
                  <c:v>6.5919999999999996</c:v>
                </c:pt>
                <c:pt idx="65">
                  <c:v>6.6950000000000003</c:v>
                </c:pt>
                <c:pt idx="66">
                  <c:v>6.798</c:v>
                </c:pt>
                <c:pt idx="67">
                  <c:v>6.9009999999999998</c:v>
                </c:pt>
                <c:pt idx="68">
                  <c:v>7.0039999999999996</c:v>
                </c:pt>
                <c:pt idx="69">
                  <c:v>7.1070000000000002</c:v>
                </c:pt>
                <c:pt idx="70">
                  <c:v>7.21</c:v>
                </c:pt>
                <c:pt idx="71">
                  <c:v>7.3129999999999997</c:v>
                </c:pt>
                <c:pt idx="72">
                  <c:v>7.4160000000000004</c:v>
                </c:pt>
                <c:pt idx="73">
                  <c:v>7.5190000000000001</c:v>
                </c:pt>
                <c:pt idx="74">
                  <c:v>7.6219999999999999</c:v>
                </c:pt>
                <c:pt idx="75">
                  <c:v>7.7249999999999996</c:v>
                </c:pt>
                <c:pt idx="76">
                  <c:v>7.8280000000000003</c:v>
                </c:pt>
                <c:pt idx="77">
                  <c:v>7.931</c:v>
                </c:pt>
                <c:pt idx="78">
                  <c:v>8.0340000000000007</c:v>
                </c:pt>
                <c:pt idx="79">
                  <c:v>8.1370000000000005</c:v>
                </c:pt>
                <c:pt idx="80">
                  <c:v>8.24</c:v>
                </c:pt>
                <c:pt idx="81">
                  <c:v>8.343</c:v>
                </c:pt>
                <c:pt idx="82">
                  <c:v>8.4459999999999997</c:v>
                </c:pt>
                <c:pt idx="83">
                  <c:v>8.5489999999999995</c:v>
                </c:pt>
                <c:pt idx="84">
                  <c:v>8.6519999999999992</c:v>
                </c:pt>
                <c:pt idx="85">
                  <c:v>8.7550000000000008</c:v>
                </c:pt>
                <c:pt idx="86">
                  <c:v>8.8580000000000005</c:v>
                </c:pt>
                <c:pt idx="87">
                  <c:v>8.9610000000000003</c:v>
                </c:pt>
                <c:pt idx="88">
                  <c:v>9.0640000000000001</c:v>
                </c:pt>
                <c:pt idx="89">
                  <c:v>9.1669999999999998</c:v>
                </c:pt>
                <c:pt idx="90">
                  <c:v>9.27</c:v>
                </c:pt>
                <c:pt idx="91">
                  <c:v>9.3729999999999993</c:v>
                </c:pt>
                <c:pt idx="92">
                  <c:v>9.4760000000000009</c:v>
                </c:pt>
                <c:pt idx="93">
                  <c:v>9.5790000000000006</c:v>
                </c:pt>
                <c:pt idx="94">
                  <c:v>9.6820000000000004</c:v>
                </c:pt>
                <c:pt idx="95">
                  <c:v>9.7850000000000001</c:v>
                </c:pt>
                <c:pt idx="96">
                  <c:v>9.8879999999999999</c:v>
                </c:pt>
                <c:pt idx="97">
                  <c:v>9.9909999999999997</c:v>
                </c:pt>
                <c:pt idx="98">
                  <c:v>10.093999999999999</c:v>
                </c:pt>
                <c:pt idx="99">
                  <c:v>10.196999999999999</c:v>
                </c:pt>
                <c:pt idx="100">
                  <c:v>10.3</c:v>
                </c:pt>
                <c:pt idx="101">
                  <c:v>10.403</c:v>
                </c:pt>
                <c:pt idx="102">
                  <c:v>10.506</c:v>
                </c:pt>
                <c:pt idx="103">
                  <c:v>10.609</c:v>
                </c:pt>
                <c:pt idx="104">
                  <c:v>10.712</c:v>
                </c:pt>
                <c:pt idx="105">
                  <c:v>10.815</c:v>
                </c:pt>
                <c:pt idx="106">
                  <c:v>10.917999999999999</c:v>
                </c:pt>
                <c:pt idx="107">
                  <c:v>11.021000000000001</c:v>
                </c:pt>
                <c:pt idx="108">
                  <c:v>11.124000000000001</c:v>
                </c:pt>
                <c:pt idx="109">
                  <c:v>11.227</c:v>
                </c:pt>
                <c:pt idx="110">
                  <c:v>11.33</c:v>
                </c:pt>
                <c:pt idx="111">
                  <c:v>11.433</c:v>
                </c:pt>
                <c:pt idx="112">
                  <c:v>11.536</c:v>
                </c:pt>
                <c:pt idx="113">
                  <c:v>11.638999999999999</c:v>
                </c:pt>
                <c:pt idx="114">
                  <c:v>11.742000000000001</c:v>
                </c:pt>
                <c:pt idx="115">
                  <c:v>11.845000000000001</c:v>
                </c:pt>
                <c:pt idx="116">
                  <c:v>11.948</c:v>
                </c:pt>
                <c:pt idx="117">
                  <c:v>12.051</c:v>
                </c:pt>
                <c:pt idx="118">
                  <c:v>12.154</c:v>
                </c:pt>
                <c:pt idx="119">
                  <c:v>12.257</c:v>
                </c:pt>
                <c:pt idx="120">
                  <c:v>12.36</c:v>
                </c:pt>
                <c:pt idx="121">
                  <c:v>12.462999999999999</c:v>
                </c:pt>
                <c:pt idx="122">
                  <c:v>12.566000000000001</c:v>
                </c:pt>
                <c:pt idx="123">
                  <c:v>12.669</c:v>
                </c:pt>
                <c:pt idx="124">
                  <c:v>12.772</c:v>
                </c:pt>
                <c:pt idx="125">
                  <c:v>12.875</c:v>
                </c:pt>
                <c:pt idx="126">
                  <c:v>12.978</c:v>
                </c:pt>
                <c:pt idx="127">
                  <c:v>13.081</c:v>
                </c:pt>
                <c:pt idx="128">
                  <c:v>13.183999999999999</c:v>
                </c:pt>
                <c:pt idx="129">
                  <c:v>13.287000000000001</c:v>
                </c:pt>
                <c:pt idx="130">
                  <c:v>13.39</c:v>
                </c:pt>
                <c:pt idx="131">
                  <c:v>13.493</c:v>
                </c:pt>
                <c:pt idx="132">
                  <c:v>13.596</c:v>
                </c:pt>
                <c:pt idx="133">
                  <c:v>13.699</c:v>
                </c:pt>
                <c:pt idx="134">
                  <c:v>13.802</c:v>
                </c:pt>
              </c:numCache>
            </c:numRef>
          </c:xVal>
          <c:yVal>
            <c:numRef>
              <c:f>'imagen 41 perfil'!$B$2:$B$136</c:f>
              <c:numCache>
                <c:formatCode>General</c:formatCode>
                <c:ptCount val="135"/>
                <c:pt idx="0">
                  <c:v>155.06790000000001</c:v>
                </c:pt>
                <c:pt idx="1">
                  <c:v>146.34370000000001</c:v>
                </c:pt>
                <c:pt idx="2">
                  <c:v>132.44569999999999</c:v>
                </c:pt>
                <c:pt idx="3">
                  <c:v>130.59649999999999</c:v>
                </c:pt>
                <c:pt idx="4">
                  <c:v>142.02500000000001</c:v>
                </c:pt>
                <c:pt idx="5">
                  <c:v>132.98240000000001</c:v>
                </c:pt>
                <c:pt idx="6">
                  <c:v>134.68100000000001</c:v>
                </c:pt>
                <c:pt idx="7">
                  <c:v>127.217</c:v>
                </c:pt>
                <c:pt idx="8">
                  <c:v>121.3673</c:v>
                </c:pt>
                <c:pt idx="9">
                  <c:v>131.7807</c:v>
                </c:pt>
                <c:pt idx="10">
                  <c:v>133.5112</c:v>
                </c:pt>
                <c:pt idx="11">
                  <c:v>121.4436</c:v>
                </c:pt>
                <c:pt idx="12">
                  <c:v>151.22130000000001</c:v>
                </c:pt>
                <c:pt idx="13">
                  <c:v>130.9556</c:v>
                </c:pt>
                <c:pt idx="14">
                  <c:v>150.25059999999999</c:v>
                </c:pt>
                <c:pt idx="15">
                  <c:v>160.40889999999999</c:v>
                </c:pt>
                <c:pt idx="16">
                  <c:v>138.3878</c:v>
                </c:pt>
                <c:pt idx="17">
                  <c:v>150.8349</c:v>
                </c:pt>
                <c:pt idx="18">
                  <c:v>141.58439999999999</c:v>
                </c:pt>
                <c:pt idx="19">
                  <c:v>167.7878</c:v>
                </c:pt>
                <c:pt idx="20">
                  <c:v>155.25659999999999</c:v>
                </c:pt>
                <c:pt idx="21">
                  <c:v>157.41849999999999</c:v>
                </c:pt>
                <c:pt idx="22">
                  <c:v>158.82689999999999</c:v>
                </c:pt>
                <c:pt idx="23">
                  <c:v>165.1069</c:v>
                </c:pt>
                <c:pt idx="24">
                  <c:v>166.5402</c:v>
                </c:pt>
                <c:pt idx="25">
                  <c:v>173.89169999999999</c:v>
                </c:pt>
                <c:pt idx="26">
                  <c:v>156.55439999999999</c:v>
                </c:pt>
                <c:pt idx="27">
                  <c:v>170.8314</c:v>
                </c:pt>
                <c:pt idx="28">
                  <c:v>163.24019999999999</c:v>
                </c:pt>
                <c:pt idx="29">
                  <c:v>142.27440000000001</c:v>
                </c:pt>
                <c:pt idx="30">
                  <c:v>151.29320000000001</c:v>
                </c:pt>
                <c:pt idx="31">
                  <c:v>147.2979</c:v>
                </c:pt>
                <c:pt idx="32">
                  <c:v>144.51060000000001</c:v>
                </c:pt>
                <c:pt idx="33">
                  <c:v>146.3331</c:v>
                </c:pt>
                <c:pt idx="34">
                  <c:v>150.62780000000001</c:v>
                </c:pt>
                <c:pt idx="35">
                  <c:v>143.0487</c:v>
                </c:pt>
                <c:pt idx="36">
                  <c:v>147.8365</c:v>
                </c:pt>
                <c:pt idx="37">
                  <c:v>136.09649999999999</c:v>
                </c:pt>
                <c:pt idx="38">
                  <c:v>131.95320000000001</c:v>
                </c:pt>
                <c:pt idx="39">
                  <c:v>132.63560000000001</c:v>
                </c:pt>
                <c:pt idx="40">
                  <c:v>126.6152</c:v>
                </c:pt>
                <c:pt idx="41">
                  <c:v>131.65770000000001</c:v>
                </c:pt>
                <c:pt idx="42">
                  <c:v>152.4914</c:v>
                </c:pt>
                <c:pt idx="43">
                  <c:v>142.4666</c:v>
                </c:pt>
                <c:pt idx="44">
                  <c:v>144.6285</c:v>
                </c:pt>
                <c:pt idx="45">
                  <c:v>144.3903</c:v>
                </c:pt>
                <c:pt idx="46">
                  <c:v>125.2693</c:v>
                </c:pt>
                <c:pt idx="47">
                  <c:v>137.2191</c:v>
                </c:pt>
                <c:pt idx="48">
                  <c:v>130.13839999999999</c:v>
                </c:pt>
                <c:pt idx="49">
                  <c:v>137.81970000000001</c:v>
                </c:pt>
                <c:pt idx="50">
                  <c:v>137.57509999999999</c:v>
                </c:pt>
                <c:pt idx="51">
                  <c:v>137.9271</c:v>
                </c:pt>
                <c:pt idx="52">
                  <c:v>131.99850000000001</c:v>
                </c:pt>
                <c:pt idx="53">
                  <c:v>127.31870000000001</c:v>
                </c:pt>
                <c:pt idx="54">
                  <c:v>131.4436</c:v>
                </c:pt>
                <c:pt idx="55">
                  <c:v>132.50749999999999</c:v>
                </c:pt>
                <c:pt idx="56">
                  <c:v>130.0067</c:v>
                </c:pt>
                <c:pt idx="57">
                  <c:v>118.71040000000001</c:v>
                </c:pt>
                <c:pt idx="58">
                  <c:v>123.8918</c:v>
                </c:pt>
                <c:pt idx="59">
                  <c:v>113.9469</c:v>
                </c:pt>
                <c:pt idx="60">
                  <c:v>109.0441</c:v>
                </c:pt>
                <c:pt idx="61">
                  <c:v>123.36799999999999</c:v>
                </c:pt>
                <c:pt idx="62">
                  <c:v>115.8959</c:v>
                </c:pt>
                <c:pt idx="63">
                  <c:v>116.3986</c:v>
                </c:pt>
                <c:pt idx="64">
                  <c:v>118.9704</c:v>
                </c:pt>
                <c:pt idx="65">
                  <c:v>117.3944</c:v>
                </c:pt>
                <c:pt idx="66">
                  <c:v>112.1741</c:v>
                </c:pt>
                <c:pt idx="67">
                  <c:v>121.0577</c:v>
                </c:pt>
                <c:pt idx="68">
                  <c:v>123.0951</c:v>
                </c:pt>
                <c:pt idx="69">
                  <c:v>128.25399999999999</c:v>
                </c:pt>
                <c:pt idx="70">
                  <c:v>136.83949999999999</c:v>
                </c:pt>
                <c:pt idx="71">
                  <c:v>123.40819999999999</c:v>
                </c:pt>
                <c:pt idx="72">
                  <c:v>118.01090000000001</c:v>
                </c:pt>
                <c:pt idx="73">
                  <c:v>116.38720000000001</c:v>
                </c:pt>
                <c:pt idx="74">
                  <c:v>125.4726</c:v>
                </c:pt>
                <c:pt idx="75">
                  <c:v>107.42700000000001</c:v>
                </c:pt>
                <c:pt idx="76">
                  <c:v>106.5067</c:v>
                </c:pt>
                <c:pt idx="77">
                  <c:v>113.40900000000001</c:v>
                </c:pt>
                <c:pt idx="78">
                  <c:v>111.3818</c:v>
                </c:pt>
                <c:pt idx="79">
                  <c:v>105.705</c:v>
                </c:pt>
                <c:pt idx="80">
                  <c:v>107.7851</c:v>
                </c:pt>
                <c:pt idx="81">
                  <c:v>105.1374</c:v>
                </c:pt>
                <c:pt idx="82">
                  <c:v>103.2508</c:v>
                </c:pt>
                <c:pt idx="83">
                  <c:v>111.7637</c:v>
                </c:pt>
                <c:pt idx="84">
                  <c:v>112.00579999999999</c:v>
                </c:pt>
                <c:pt idx="85">
                  <c:v>113.916</c:v>
                </c:pt>
                <c:pt idx="86">
                  <c:v>123.6079</c:v>
                </c:pt>
                <c:pt idx="87">
                  <c:v>126.78660000000001</c:v>
                </c:pt>
                <c:pt idx="88">
                  <c:v>120.3117</c:v>
                </c:pt>
                <c:pt idx="89">
                  <c:v>126.2825</c:v>
                </c:pt>
                <c:pt idx="90">
                  <c:v>117.8818</c:v>
                </c:pt>
                <c:pt idx="91">
                  <c:v>110.3099</c:v>
                </c:pt>
                <c:pt idx="92">
                  <c:v>113.8552</c:v>
                </c:pt>
                <c:pt idx="93">
                  <c:v>130.23859999999999</c:v>
                </c:pt>
                <c:pt idx="94">
                  <c:v>119.1473</c:v>
                </c:pt>
                <c:pt idx="95">
                  <c:v>108.7269</c:v>
                </c:pt>
                <c:pt idx="96">
                  <c:v>105.598</c:v>
                </c:pt>
                <c:pt idx="97">
                  <c:v>106.6635</c:v>
                </c:pt>
                <c:pt idx="98">
                  <c:v>119.5245</c:v>
                </c:pt>
                <c:pt idx="99">
                  <c:v>115.9764</c:v>
                </c:pt>
                <c:pt idx="100">
                  <c:v>117.2659</c:v>
                </c:pt>
                <c:pt idx="101">
                  <c:v>115.8749</c:v>
                </c:pt>
                <c:pt idx="102">
                  <c:v>124.0723</c:v>
                </c:pt>
                <c:pt idx="103">
                  <c:v>110.77070000000001</c:v>
                </c:pt>
                <c:pt idx="104">
                  <c:v>94.163899999999998</c:v>
                </c:pt>
                <c:pt idx="105">
                  <c:v>94.2423</c:v>
                </c:pt>
                <c:pt idx="106">
                  <c:v>106.19119999999999</c:v>
                </c:pt>
                <c:pt idx="107">
                  <c:v>119.13339999999999</c:v>
                </c:pt>
                <c:pt idx="108">
                  <c:v>118.9241</c:v>
                </c:pt>
                <c:pt idx="109">
                  <c:v>119.2204</c:v>
                </c:pt>
                <c:pt idx="110">
                  <c:v>116.9648</c:v>
                </c:pt>
                <c:pt idx="111">
                  <c:v>105.8481</c:v>
                </c:pt>
                <c:pt idx="112">
                  <c:v>103.23090000000001</c:v>
                </c:pt>
                <c:pt idx="113">
                  <c:v>93.346199999999996</c:v>
                </c:pt>
                <c:pt idx="114">
                  <c:v>96.591899999999995</c:v>
                </c:pt>
                <c:pt idx="115">
                  <c:v>98.087999999999994</c:v>
                </c:pt>
                <c:pt idx="116">
                  <c:v>105.2662</c:v>
                </c:pt>
                <c:pt idx="117">
                  <c:v>110.9962</c:v>
                </c:pt>
                <c:pt idx="118">
                  <c:v>107.7777</c:v>
                </c:pt>
                <c:pt idx="119">
                  <c:v>122.0639</c:v>
                </c:pt>
                <c:pt idx="120">
                  <c:v>146.7611</c:v>
                </c:pt>
                <c:pt idx="121">
                  <c:v>153.80529999999999</c:v>
                </c:pt>
                <c:pt idx="122">
                  <c:v>165.04939999999999</c:v>
                </c:pt>
                <c:pt idx="123">
                  <c:v>143.32239999999999</c:v>
                </c:pt>
                <c:pt idx="124">
                  <c:v>125.80419999999999</c:v>
                </c:pt>
                <c:pt idx="125">
                  <c:v>113.7259</c:v>
                </c:pt>
                <c:pt idx="126">
                  <c:v>112.6335</c:v>
                </c:pt>
                <c:pt idx="127">
                  <c:v>121.77209999999999</c:v>
                </c:pt>
                <c:pt idx="128">
                  <c:v>117.1707</c:v>
                </c:pt>
                <c:pt idx="129">
                  <c:v>112.9397</c:v>
                </c:pt>
                <c:pt idx="130">
                  <c:v>120.5715</c:v>
                </c:pt>
                <c:pt idx="131">
                  <c:v>116.6318</c:v>
                </c:pt>
                <c:pt idx="132">
                  <c:v>104.8378</c:v>
                </c:pt>
                <c:pt idx="133">
                  <c:v>97.147999999999996</c:v>
                </c:pt>
                <c:pt idx="134">
                  <c:v>98.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4E9-4681-9756-21C8A431C2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0376448"/>
        <c:axId val="2000374368"/>
      </c:scatterChart>
      <c:valAx>
        <c:axId val="2000376448"/>
        <c:scaling>
          <c:orientation val="minMax"/>
          <c:max val="1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Distance (</a:t>
                </a:r>
                <a:r>
                  <a:rPr lang="el-GR" sz="1600"/>
                  <a:t>μ</a:t>
                </a:r>
                <a:r>
                  <a:rPr lang="es-AR" sz="1600"/>
                  <a:t>m)</a:t>
                </a:r>
                <a:endParaRPr lang="en-US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2000374368"/>
        <c:crosses val="autoZero"/>
        <c:crossBetween val="midCat"/>
      </c:valAx>
      <c:valAx>
        <c:axId val="2000374368"/>
        <c:scaling>
          <c:orientation val="minMax"/>
          <c:max val="180"/>
          <c:min val="9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Fluorescence intensity (a.u.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A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AR"/>
          </a:p>
        </c:txPr>
        <c:crossAx val="200037644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A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A21EA8-E2B8-4019-B3EC-C6F8C587B8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401A62D9-9403-4470-A4E1-E2426CE397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67" indent="0" algn="ctr">
              <a:buNone/>
              <a:defRPr sz="2000"/>
            </a:lvl2pPr>
            <a:lvl3pPr marL="914332" indent="0" algn="ctr">
              <a:buNone/>
              <a:defRPr sz="1800"/>
            </a:lvl3pPr>
            <a:lvl4pPr marL="1371498" indent="0" algn="ctr">
              <a:buNone/>
              <a:defRPr sz="1600"/>
            </a:lvl4pPr>
            <a:lvl5pPr marL="1828664" indent="0" algn="ctr">
              <a:buNone/>
              <a:defRPr sz="1600"/>
            </a:lvl5pPr>
            <a:lvl6pPr marL="2285830" indent="0" algn="ctr">
              <a:buNone/>
              <a:defRPr sz="1600"/>
            </a:lvl6pPr>
            <a:lvl7pPr marL="2742994" indent="0" algn="ctr">
              <a:buNone/>
              <a:defRPr sz="1600"/>
            </a:lvl7pPr>
            <a:lvl8pPr marL="3200160" indent="0" algn="ctr">
              <a:buNone/>
              <a:defRPr sz="1600"/>
            </a:lvl8pPr>
            <a:lvl9pPr marL="3657327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767C504-8DFF-4414-9B6D-EBFBD789D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B66341E-BCF5-4D83-ABF7-796898FF9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0188CC2-752C-4C01-8B54-467B16BAC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269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6177BE8-7B05-4303-AAC9-F6182C3E19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FAAAAED-B0CE-4B2A-909C-C5D7B745C0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8F4AD7B-F7F7-4E82-97EC-60DF64684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5765C67-943F-4E30-A03E-5C879E657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B15560A-1F48-4719-8364-95115B440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185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3C1B5C8-9E6F-45E8-9A6D-13B37834E5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8274273-C0A6-4018-BFF0-EA5159AFA9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3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A3F3A23-4159-4A74-936A-53599F83A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914A795-A55B-41A7-B482-2CA33CD5C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2ACC800-BFA3-4C75-AF62-822AEE649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660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9FEC68-431B-476F-9185-C7D8FE460F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C823079-1E51-44F3-9E68-2A30ECABFB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72ACB9D-0C8B-4EB1-83C3-09874C05A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B14ED80-59E5-4673-8113-22A333EDC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B94719F-A8E5-4517-801D-D0E0659D7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550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E12B88-0A20-4D2B-BCF6-3FBDC5CF6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4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3ED5A97-AA2D-4649-B756-1F6D48A24E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9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6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3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4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66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83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99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1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3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78E494D-FB89-49E9-849D-848C11FAE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A06A3BF-F667-4694-A6C2-C9F6F4FE4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1E69766-5B1A-47D7-AB2D-FE9DA20E1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04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407CF6C-5FCC-404D-AFA7-67BB99E976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0F68A79-7D44-4223-A24A-AF208921B1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8F392BA-E54D-435E-BEBF-F2FC9F6E82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D717392-5430-4C96-806F-5876B88E9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E59A34A-E375-4369-BCDF-7B2A9523D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7AD3693-DB20-4E6D-9BB4-84AB53525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496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471141-027A-4E89-9AE8-84F0C7F695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1E2CB88-9AD6-433A-920F-68F38EF0B6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67" indent="0">
              <a:buNone/>
              <a:defRPr sz="2000" b="1"/>
            </a:lvl2pPr>
            <a:lvl3pPr marL="914332" indent="0">
              <a:buNone/>
              <a:defRPr sz="1800" b="1"/>
            </a:lvl3pPr>
            <a:lvl4pPr marL="1371498" indent="0">
              <a:buNone/>
              <a:defRPr sz="1600" b="1"/>
            </a:lvl4pPr>
            <a:lvl5pPr marL="1828664" indent="0">
              <a:buNone/>
              <a:defRPr sz="1600" b="1"/>
            </a:lvl5pPr>
            <a:lvl6pPr marL="2285830" indent="0">
              <a:buNone/>
              <a:defRPr sz="1600" b="1"/>
            </a:lvl6pPr>
            <a:lvl7pPr marL="2742994" indent="0">
              <a:buNone/>
              <a:defRPr sz="1600" b="1"/>
            </a:lvl7pPr>
            <a:lvl8pPr marL="3200160" indent="0">
              <a:buNone/>
              <a:defRPr sz="1600" b="1"/>
            </a:lvl8pPr>
            <a:lvl9pPr marL="3657327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6C7AED7-9EA1-43DC-8E97-44FB536013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E9EA75D3-C12C-41AA-94F4-EDC00680B7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67" indent="0">
              <a:buNone/>
              <a:defRPr sz="2000" b="1"/>
            </a:lvl2pPr>
            <a:lvl3pPr marL="914332" indent="0">
              <a:buNone/>
              <a:defRPr sz="1800" b="1"/>
            </a:lvl3pPr>
            <a:lvl4pPr marL="1371498" indent="0">
              <a:buNone/>
              <a:defRPr sz="1600" b="1"/>
            </a:lvl4pPr>
            <a:lvl5pPr marL="1828664" indent="0">
              <a:buNone/>
              <a:defRPr sz="1600" b="1"/>
            </a:lvl5pPr>
            <a:lvl6pPr marL="2285830" indent="0">
              <a:buNone/>
              <a:defRPr sz="1600" b="1"/>
            </a:lvl6pPr>
            <a:lvl7pPr marL="2742994" indent="0">
              <a:buNone/>
              <a:defRPr sz="1600" b="1"/>
            </a:lvl7pPr>
            <a:lvl8pPr marL="3200160" indent="0">
              <a:buNone/>
              <a:defRPr sz="1600" b="1"/>
            </a:lvl8pPr>
            <a:lvl9pPr marL="3657327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72AD9D9A-DAEE-4CFC-BDA9-EC1DB8300B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ED79D65-391D-49A3-AFA3-11C837373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A32581C-64D7-4DCF-98B0-029111D71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35A73D8-A000-424F-9CE7-F46ACBC15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929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4F68FF4-9437-4F24-8E4B-53C7345435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B54ABE2-04ED-441C-A543-A66E9E07E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C319D70-281F-4A29-9F9B-8EF395C4F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9E3FCA4-245E-4EBD-9F8F-F00CD86F6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205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A7E00AC-110E-415C-9F7D-2E6E0EC16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152DF81-EAAB-47F7-94EE-59D9904D3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7EBCA9D9-E565-4C3C-8C7A-E1CC1A94A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540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C9DB1AC-8DA9-4732-8D46-25E18446E3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5F98681-99CF-41DC-A0B0-0BFC06AB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31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ACF8979-9433-4000-A7FF-0FECF07B9B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7" indent="0">
              <a:buNone/>
              <a:defRPr sz="1400"/>
            </a:lvl2pPr>
            <a:lvl3pPr marL="914332" indent="0">
              <a:buNone/>
              <a:defRPr sz="1200"/>
            </a:lvl3pPr>
            <a:lvl4pPr marL="1371498" indent="0">
              <a:buNone/>
              <a:defRPr sz="1000"/>
            </a:lvl4pPr>
            <a:lvl5pPr marL="1828664" indent="0">
              <a:buNone/>
              <a:defRPr sz="1000"/>
            </a:lvl5pPr>
            <a:lvl6pPr marL="2285830" indent="0">
              <a:buNone/>
              <a:defRPr sz="1000"/>
            </a:lvl6pPr>
            <a:lvl7pPr marL="2742994" indent="0">
              <a:buNone/>
              <a:defRPr sz="1000"/>
            </a:lvl7pPr>
            <a:lvl8pPr marL="3200160" indent="0">
              <a:buNone/>
              <a:defRPr sz="1000"/>
            </a:lvl8pPr>
            <a:lvl9pPr marL="3657327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E27FD85-8C7A-48BB-B582-2B1F10CDD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96FAD8F-7F39-4E63-8E1F-0BFAF1E1F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5F51979-56B1-4F08-9E89-2A2408ED6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958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4439F1-2FF8-4D05-BC54-CAAE611FDD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7E35C5D0-4C69-49FB-8EEC-0BDD33C766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31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67" indent="0">
              <a:buNone/>
              <a:defRPr sz="2800"/>
            </a:lvl2pPr>
            <a:lvl3pPr marL="914332" indent="0">
              <a:buNone/>
              <a:defRPr sz="2400"/>
            </a:lvl3pPr>
            <a:lvl4pPr marL="1371498" indent="0">
              <a:buNone/>
              <a:defRPr sz="2000"/>
            </a:lvl4pPr>
            <a:lvl5pPr marL="1828664" indent="0">
              <a:buNone/>
              <a:defRPr sz="2000"/>
            </a:lvl5pPr>
            <a:lvl6pPr marL="2285830" indent="0">
              <a:buNone/>
              <a:defRPr sz="2000"/>
            </a:lvl6pPr>
            <a:lvl7pPr marL="2742994" indent="0">
              <a:buNone/>
              <a:defRPr sz="2000"/>
            </a:lvl7pPr>
            <a:lvl8pPr marL="3200160" indent="0">
              <a:buNone/>
              <a:defRPr sz="2000"/>
            </a:lvl8pPr>
            <a:lvl9pPr marL="365732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AC7B7DE-F55A-481C-B645-13CFDC768B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7" indent="0">
              <a:buNone/>
              <a:defRPr sz="1400"/>
            </a:lvl2pPr>
            <a:lvl3pPr marL="914332" indent="0">
              <a:buNone/>
              <a:defRPr sz="1200"/>
            </a:lvl3pPr>
            <a:lvl4pPr marL="1371498" indent="0">
              <a:buNone/>
              <a:defRPr sz="1000"/>
            </a:lvl4pPr>
            <a:lvl5pPr marL="1828664" indent="0">
              <a:buNone/>
              <a:defRPr sz="1000"/>
            </a:lvl5pPr>
            <a:lvl6pPr marL="2285830" indent="0">
              <a:buNone/>
              <a:defRPr sz="1000"/>
            </a:lvl6pPr>
            <a:lvl7pPr marL="2742994" indent="0">
              <a:buNone/>
              <a:defRPr sz="1000"/>
            </a:lvl7pPr>
            <a:lvl8pPr marL="3200160" indent="0">
              <a:buNone/>
              <a:defRPr sz="1000"/>
            </a:lvl8pPr>
            <a:lvl9pPr marL="3657327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7771964-6342-4461-AAB3-6A6C4967F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01023F8-F68D-4240-A382-5751B99A4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E8E16CC-DD7B-4389-9D21-6E36594E9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648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D0E0647-591F-427F-8E27-03273E06E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E54A417-1095-4EF5-AB78-59A11967D7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12A2D07-8710-48FB-B934-F54D276BC8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6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4F2EA-E78C-4E71-871E-DADE577E4B19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AC5731E-CFE1-4F01-AB39-3D5989D55E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6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D556CEE-E24C-4D13-BAA5-81EEBCB96F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6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6F853-DE6A-47F3-AD7C-A4E7D6E8D8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316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3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84" indent="-228584" algn="l" defTabSz="91433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50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14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80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47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12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78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744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910" indent="-228584" algn="l" defTabSz="91433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67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32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98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64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30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94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160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327" algn="l" defTabSz="91433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jpeg"/><Relationship Id="rId3" Type="http://schemas.openxmlformats.org/officeDocument/2006/relationships/chart" Target="../charts/chart1.xml"/><Relationship Id="rId7" Type="http://schemas.openxmlformats.org/officeDocument/2006/relationships/image" Target="../media/image1.jpe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4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jpeg"/><Relationship Id="rId3" Type="http://schemas.openxmlformats.org/officeDocument/2006/relationships/chart" Target="../charts/chart2.xml"/><Relationship Id="rId7" Type="http://schemas.openxmlformats.org/officeDocument/2006/relationships/image" Target="../media/image1.jpe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8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jpeg"/><Relationship Id="rId3" Type="http://schemas.openxmlformats.org/officeDocument/2006/relationships/chart" Target="../charts/chart3.xml"/><Relationship Id="rId7" Type="http://schemas.openxmlformats.org/officeDocument/2006/relationships/image" Target="../media/image1.jpe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10.ti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jpeg"/><Relationship Id="rId3" Type="http://schemas.openxmlformats.org/officeDocument/2006/relationships/chart" Target="../charts/chart4.xml"/><Relationship Id="rId7" Type="http://schemas.openxmlformats.org/officeDocument/2006/relationships/image" Target="../media/image1.jpe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1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BE8921-1154-4988-B0B7-76C39581A0B2}"/>
              </a:ext>
            </a:extLst>
          </p:cNvPr>
          <p:cNvSpPr txBox="1"/>
          <p:nvPr/>
        </p:nvSpPr>
        <p:spPr>
          <a:xfrm>
            <a:off x="2135562" y="2060853"/>
            <a:ext cx="810510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Nucleus-cytoskeleton communication in embryonic stem cells </a:t>
            </a:r>
          </a:p>
          <a:p>
            <a:pPr algn="ctr"/>
            <a:r>
              <a:rPr lang="en-US" sz="2400" b="1" dirty="0"/>
              <a:t>and its impact on OCT4-chromatin interactio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EC70694-2505-4654-88D4-A8D0553E27BD}"/>
              </a:ext>
            </a:extLst>
          </p:cNvPr>
          <p:cNvSpPr txBox="1"/>
          <p:nvPr/>
        </p:nvSpPr>
        <p:spPr>
          <a:xfrm>
            <a:off x="5159898" y="3019751"/>
            <a:ext cx="1643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mero JJ et al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A334FC-EC46-4DB6-A610-CC66CC8B314D}"/>
              </a:ext>
            </a:extLst>
          </p:cNvPr>
          <p:cNvSpPr txBox="1"/>
          <p:nvPr/>
        </p:nvSpPr>
        <p:spPr>
          <a:xfrm>
            <a:off x="2921322" y="4076604"/>
            <a:ext cx="621554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AR" dirty="0" err="1"/>
              <a:t>Additional</a:t>
            </a:r>
            <a:r>
              <a:rPr lang="es-AR" dirty="0"/>
              <a:t> file 16 - </a:t>
            </a:r>
            <a:r>
              <a:rPr lang="es-AR" dirty="0" err="1"/>
              <a:t>Supplementary</a:t>
            </a:r>
            <a:r>
              <a:rPr lang="es-AR" dirty="0"/>
              <a:t> </a:t>
            </a:r>
            <a:r>
              <a:rPr lang="es-AR" dirty="0" err="1"/>
              <a:t>Fig</a:t>
            </a:r>
            <a:r>
              <a:rPr lang="es-AR" dirty="0"/>
              <a:t> S7</a:t>
            </a:r>
          </a:p>
          <a:p>
            <a:pPr algn="ctr"/>
            <a:endParaRPr lang="es-AR" dirty="0"/>
          </a:p>
          <a:p>
            <a:pPr algn="ctr"/>
            <a:endParaRPr lang="es-AR" dirty="0"/>
          </a:p>
          <a:p>
            <a:pPr algn="ctr"/>
            <a:r>
              <a:rPr lang="es-AR" dirty="0" err="1"/>
              <a:t>Fluorescence</a:t>
            </a:r>
            <a:r>
              <a:rPr lang="es-AR" dirty="0"/>
              <a:t> </a:t>
            </a:r>
            <a:r>
              <a:rPr lang="es-AR" dirty="0" err="1"/>
              <a:t>intensity</a:t>
            </a:r>
            <a:r>
              <a:rPr lang="es-AR" dirty="0"/>
              <a:t> </a:t>
            </a:r>
            <a:r>
              <a:rPr lang="es-AR" dirty="0" err="1"/>
              <a:t>profiles</a:t>
            </a:r>
            <a:r>
              <a:rPr lang="es-AR" dirty="0"/>
              <a:t> </a:t>
            </a:r>
            <a:r>
              <a:rPr lang="es-AR" dirty="0" err="1"/>
              <a:t>of</a:t>
            </a:r>
            <a:r>
              <a:rPr lang="es-AR" dirty="0"/>
              <a:t> EGFP-</a:t>
            </a:r>
            <a:r>
              <a:rPr lang="es-AR" dirty="0" err="1"/>
              <a:t>actin</a:t>
            </a:r>
            <a:r>
              <a:rPr lang="es-AR" dirty="0"/>
              <a:t> at </a:t>
            </a:r>
            <a:r>
              <a:rPr lang="es-AR" dirty="0" err="1"/>
              <a:t>membrane</a:t>
            </a:r>
            <a:r>
              <a:rPr lang="es-AR" dirty="0"/>
              <a:t> </a:t>
            </a:r>
            <a:r>
              <a:rPr lang="es-AR" dirty="0" err="1"/>
              <a:t>blebs</a:t>
            </a:r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48CAAE2-1E01-40FD-865B-403DE5E1541F}"/>
              </a:ext>
            </a:extLst>
          </p:cNvPr>
          <p:cNvSpPr/>
          <p:nvPr/>
        </p:nvSpPr>
        <p:spPr>
          <a:xfrm>
            <a:off x="0" y="6525347"/>
            <a:ext cx="12191999" cy="264391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24414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2790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81687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17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BE8921-1154-4988-B0B7-76C39581A0B2}"/>
              </a:ext>
            </a:extLst>
          </p:cNvPr>
          <p:cNvSpPr txBox="1"/>
          <p:nvPr/>
        </p:nvSpPr>
        <p:spPr>
          <a:xfrm>
            <a:off x="1789043" y="1859340"/>
            <a:ext cx="8825948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W4 ES cell line</a:t>
            </a:r>
            <a:endParaRPr lang="es-AR" sz="4800" b="1" dirty="0"/>
          </a:p>
          <a:p>
            <a:pPr algn="ctr"/>
            <a:endParaRPr lang="es-AR" sz="3200" dirty="0"/>
          </a:p>
          <a:p>
            <a:pPr algn="ctr"/>
            <a:r>
              <a:rPr lang="es-AR" sz="3200" dirty="0" err="1"/>
              <a:t>Transfection</a:t>
            </a:r>
            <a:r>
              <a:rPr lang="es-AR" sz="3200" dirty="0"/>
              <a:t> </a:t>
            </a:r>
            <a:r>
              <a:rPr lang="es-AR" sz="3200" dirty="0" err="1"/>
              <a:t>of</a:t>
            </a:r>
            <a:r>
              <a:rPr lang="es-AR" sz="3200" dirty="0"/>
              <a:t> </a:t>
            </a:r>
            <a:r>
              <a:rPr lang="es-AR" sz="3200" dirty="0">
                <a:solidFill>
                  <a:schemeClr val="accent6"/>
                </a:solidFill>
              </a:rPr>
              <a:t>EGFP</a:t>
            </a:r>
            <a:r>
              <a:rPr lang="es-AR" sz="3200" dirty="0"/>
              <a:t>-</a:t>
            </a:r>
            <a:r>
              <a:rPr lang="es-AR" sz="3200" dirty="0" err="1"/>
              <a:t>actin</a:t>
            </a:r>
            <a:r>
              <a:rPr lang="es-AR" sz="3200" dirty="0"/>
              <a:t> and H2B-</a:t>
            </a:r>
            <a:r>
              <a:rPr lang="es-AR" sz="3200" dirty="0">
                <a:solidFill>
                  <a:srgbClr val="FF0000"/>
                </a:solidFill>
              </a:rPr>
              <a:t>mCherry</a:t>
            </a:r>
            <a:endParaRPr lang="en-US" sz="3200" dirty="0">
              <a:solidFill>
                <a:srgbClr val="FF0000"/>
              </a:solidFill>
            </a:endParaRPr>
          </a:p>
          <a:p>
            <a:pPr algn="ctr"/>
            <a:endParaRPr lang="en-US" sz="4800" b="1" dirty="0"/>
          </a:p>
        </p:txBody>
      </p:sp>
      <p:sp>
        <p:nvSpPr>
          <p:cNvPr id="7" name="Rectangle 8">
            <a:extLst>
              <a:ext uri="{FF2B5EF4-FFF2-40B4-BE49-F238E27FC236}">
                <a16:creationId xmlns:a16="http://schemas.microsoft.com/office/drawing/2014/main" id="{AD10167E-29D4-4991-BA3B-0A0677BE9647}"/>
              </a:ext>
            </a:extLst>
          </p:cNvPr>
          <p:cNvSpPr/>
          <p:nvPr/>
        </p:nvSpPr>
        <p:spPr>
          <a:xfrm>
            <a:off x="0" y="6525347"/>
            <a:ext cx="12191999" cy="264391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2441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2789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8168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061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Una estrella de color verde&#10;&#10;Descripción generada automáticamente con confianza baja">
            <a:extLst>
              <a:ext uri="{FF2B5EF4-FFF2-40B4-BE49-F238E27FC236}">
                <a16:creationId xmlns:a16="http://schemas.microsoft.com/office/drawing/2014/main" id="{8D517889-CBDF-4983-99C1-F2A81B4330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075" y="2092084"/>
            <a:ext cx="2241791" cy="2241791"/>
          </a:xfrm>
          <a:prstGeom prst="rect">
            <a:avLst/>
          </a:prstGeom>
        </p:spPr>
      </p:pic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864A2D11-AB4E-4BC3-AFEE-9E6EEB976E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8882772"/>
              </p:ext>
            </p:extLst>
          </p:nvPr>
        </p:nvGraphicFramePr>
        <p:xfrm>
          <a:off x="5510213" y="1762126"/>
          <a:ext cx="5342242" cy="30884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2" name="Imagen 11" descr="Imagen que contiene animal, gusano, verde, luz&#10;&#10;Descripción generada automáticamente">
            <a:extLst>
              <a:ext uri="{FF2B5EF4-FFF2-40B4-BE49-F238E27FC236}">
                <a16:creationId xmlns:a16="http://schemas.microsoft.com/office/drawing/2014/main" id="{D0BCF453-8CBF-4233-A5DA-16568038AD7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7511" y="2092084"/>
            <a:ext cx="2241791" cy="2250582"/>
          </a:xfrm>
          <a:prstGeom prst="rect">
            <a:avLst/>
          </a:prstGeom>
        </p:spPr>
      </p:pic>
      <p:sp>
        <p:nvSpPr>
          <p:cNvPr id="15" name="Rectangle 8">
            <a:extLst>
              <a:ext uri="{FF2B5EF4-FFF2-40B4-BE49-F238E27FC236}">
                <a16:creationId xmlns:a16="http://schemas.microsoft.com/office/drawing/2014/main" id="{28FF4E38-B8CD-4621-B9B7-5CF985FF8615}"/>
              </a:ext>
            </a:extLst>
          </p:cNvPr>
          <p:cNvSpPr/>
          <p:nvPr/>
        </p:nvSpPr>
        <p:spPr>
          <a:xfrm>
            <a:off x="0" y="6525347"/>
            <a:ext cx="12191999" cy="264391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C52E083B-80A4-4310-8583-0879344F810A}"/>
              </a:ext>
            </a:extLst>
          </p:cNvPr>
          <p:cNvSpPr txBox="1"/>
          <p:nvPr/>
        </p:nvSpPr>
        <p:spPr>
          <a:xfrm>
            <a:off x="10501897" y="6019998"/>
            <a:ext cx="1602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dirty="0" err="1"/>
              <a:t>Image</a:t>
            </a:r>
            <a:r>
              <a:rPr lang="es-AR" dirty="0"/>
              <a:t> 0002.tiff</a:t>
            </a:r>
          </a:p>
        </p:txBody>
      </p:sp>
      <p:cxnSp>
        <p:nvCxnSpPr>
          <p:cNvPr id="18" name="Conector recto 17">
            <a:extLst>
              <a:ext uri="{FF2B5EF4-FFF2-40B4-BE49-F238E27FC236}">
                <a16:creationId xmlns:a16="http://schemas.microsoft.com/office/drawing/2014/main" id="{3A569BDF-41AC-4746-84D1-389065057F97}"/>
              </a:ext>
            </a:extLst>
          </p:cNvPr>
          <p:cNvCxnSpPr/>
          <p:nvPr/>
        </p:nvCxnSpPr>
        <p:spPr>
          <a:xfrm>
            <a:off x="685799" y="4210050"/>
            <a:ext cx="622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a16="http://schemas.microsoft.com/office/drawing/2014/main" id="{9D964182-C58D-4006-B2C2-6FA7D6D7B94D}"/>
              </a:ext>
            </a:extLst>
          </p:cNvPr>
          <p:cNvSpPr txBox="1"/>
          <p:nvPr/>
        </p:nvSpPr>
        <p:spPr>
          <a:xfrm>
            <a:off x="781050" y="4006011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00" dirty="0">
                <a:solidFill>
                  <a:schemeClr val="bg1"/>
                </a:solidFill>
              </a:rPr>
              <a:t>5</a:t>
            </a:r>
            <a:r>
              <a:rPr lang="el-GR" sz="1000" dirty="0">
                <a:solidFill>
                  <a:schemeClr val="bg1"/>
                </a:solidFill>
              </a:rPr>
              <a:t>μ</a:t>
            </a:r>
            <a:r>
              <a:rPr lang="es-AR" sz="1000" dirty="0">
                <a:solidFill>
                  <a:schemeClr val="bg1"/>
                </a:solidFill>
              </a:rPr>
              <a:t>m</a:t>
            </a:r>
            <a:endParaRPr lang="en-US" sz="1000" dirty="0">
              <a:solidFill>
                <a:schemeClr val="bg1"/>
              </a:solidFill>
            </a:endParaRPr>
          </a:p>
        </p:txBody>
      </p:sp>
      <p:pic>
        <p:nvPicPr>
          <p:cNvPr id="3" name="Gráfico 2">
            <a:extLst>
              <a:ext uri="{FF2B5EF4-FFF2-40B4-BE49-F238E27FC236}">
                <a16:creationId xmlns:a16="http://schemas.microsoft.com/office/drawing/2014/main" id="{EDB272C8-7506-4176-A8F6-A4C86537DF2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 rot="5400000">
            <a:off x="1623571" y="3845307"/>
            <a:ext cx="194796" cy="1580011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938D77CB-4219-43E8-948C-29A7203B938B}"/>
              </a:ext>
            </a:extLst>
          </p:cNvPr>
          <p:cNvSpPr txBox="1"/>
          <p:nvPr/>
        </p:nvSpPr>
        <p:spPr>
          <a:xfrm>
            <a:off x="818048" y="4732711"/>
            <a:ext cx="391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low</a:t>
            </a:r>
            <a:endParaRPr lang="en-US" sz="1050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8A829E0E-3E7A-45AB-9DD1-639C2EFB5BF6}"/>
              </a:ext>
            </a:extLst>
          </p:cNvPr>
          <p:cNvSpPr txBox="1"/>
          <p:nvPr/>
        </p:nvSpPr>
        <p:spPr>
          <a:xfrm>
            <a:off x="2169771" y="4732711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high</a:t>
            </a:r>
            <a:endParaRPr lang="en-US" sz="1050" dirty="0"/>
          </a:p>
        </p:txBody>
      </p:sp>
      <p:pic>
        <p:nvPicPr>
          <p:cNvPr id="17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55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Una luz verde&#10;&#10;Descripción generada automáticamente con confianza media">
            <a:extLst>
              <a:ext uri="{FF2B5EF4-FFF2-40B4-BE49-F238E27FC236}">
                <a16:creationId xmlns:a16="http://schemas.microsoft.com/office/drawing/2014/main" id="{97E2C256-4981-435D-B1FB-3A51C8678B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798" y="2266949"/>
            <a:ext cx="2242800" cy="2242800"/>
          </a:xfrm>
          <a:prstGeom prst="rect">
            <a:avLst/>
          </a:prstGeom>
        </p:spPr>
      </p:pic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BE396220-6CB2-4483-B103-E2F6168D96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2428554"/>
              </p:ext>
            </p:extLst>
          </p:nvPr>
        </p:nvGraphicFramePr>
        <p:xfrm>
          <a:off x="5819774" y="1835944"/>
          <a:ext cx="5067300" cy="31861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8" name="Imagen 7" descr="Un dibujo de una persona&#10;&#10;Descripción generada automáticamente con confianza baja">
            <a:extLst>
              <a:ext uri="{FF2B5EF4-FFF2-40B4-BE49-F238E27FC236}">
                <a16:creationId xmlns:a16="http://schemas.microsoft.com/office/drawing/2014/main" id="{8835CD8B-E598-44AF-9458-943784BD65B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5274" y="2266949"/>
            <a:ext cx="2251395" cy="224280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88A14493-1A59-4F53-BDF2-FFFDD3CC891C}"/>
              </a:ext>
            </a:extLst>
          </p:cNvPr>
          <p:cNvSpPr/>
          <p:nvPr/>
        </p:nvSpPr>
        <p:spPr>
          <a:xfrm>
            <a:off x="0" y="6525347"/>
            <a:ext cx="12191999" cy="264391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DEF642A1-1F12-4C1D-A672-2738D3E7F489}"/>
              </a:ext>
            </a:extLst>
          </p:cNvPr>
          <p:cNvCxnSpPr/>
          <p:nvPr/>
        </p:nvCxnSpPr>
        <p:spPr>
          <a:xfrm>
            <a:off x="752474" y="4400550"/>
            <a:ext cx="496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446B65A-2101-4D31-A4E3-E92BBE3DC5FA}"/>
              </a:ext>
            </a:extLst>
          </p:cNvPr>
          <p:cNvSpPr txBox="1"/>
          <p:nvPr/>
        </p:nvSpPr>
        <p:spPr>
          <a:xfrm>
            <a:off x="789117" y="4154329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00" dirty="0">
                <a:solidFill>
                  <a:schemeClr val="bg1"/>
                </a:solidFill>
              </a:rPr>
              <a:t>5</a:t>
            </a:r>
            <a:r>
              <a:rPr lang="el-GR" sz="1000" dirty="0">
                <a:solidFill>
                  <a:schemeClr val="bg1"/>
                </a:solidFill>
              </a:rPr>
              <a:t>μ</a:t>
            </a:r>
            <a:r>
              <a:rPr lang="es-AR" sz="1000" dirty="0">
                <a:solidFill>
                  <a:schemeClr val="bg1"/>
                </a:solidFill>
              </a:rPr>
              <a:t>m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EC7BBFA6-325D-4E95-9861-D7F45F88204B}"/>
              </a:ext>
            </a:extLst>
          </p:cNvPr>
          <p:cNvSpPr txBox="1"/>
          <p:nvPr/>
        </p:nvSpPr>
        <p:spPr>
          <a:xfrm>
            <a:off x="10501897" y="5972175"/>
            <a:ext cx="1602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dirty="0" err="1"/>
              <a:t>Image</a:t>
            </a:r>
            <a:r>
              <a:rPr lang="es-AR" dirty="0"/>
              <a:t> 0026.tiff</a:t>
            </a:r>
          </a:p>
        </p:txBody>
      </p:sp>
      <p:pic>
        <p:nvPicPr>
          <p:cNvPr id="14" name="Gráfico 13">
            <a:extLst>
              <a:ext uri="{FF2B5EF4-FFF2-40B4-BE49-F238E27FC236}">
                <a16:creationId xmlns:a16="http://schemas.microsoft.com/office/drawing/2014/main" id="{808C6A77-7BE3-4C69-B7FE-2627E6133F1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 rot="5400000">
            <a:off x="1707461" y="3954164"/>
            <a:ext cx="194796" cy="1580011"/>
          </a:xfrm>
          <a:prstGeom prst="rect">
            <a:avLst/>
          </a:prstGeom>
        </p:spPr>
      </p:pic>
      <p:sp>
        <p:nvSpPr>
          <p:cNvPr id="15" name="CuadroTexto 14">
            <a:extLst>
              <a:ext uri="{FF2B5EF4-FFF2-40B4-BE49-F238E27FC236}">
                <a16:creationId xmlns:a16="http://schemas.microsoft.com/office/drawing/2014/main" id="{7B1CA03F-0AF2-46B8-BB54-F2C93B87C828}"/>
              </a:ext>
            </a:extLst>
          </p:cNvPr>
          <p:cNvSpPr txBox="1"/>
          <p:nvPr/>
        </p:nvSpPr>
        <p:spPr>
          <a:xfrm>
            <a:off x="901938" y="4841568"/>
            <a:ext cx="391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low</a:t>
            </a:r>
            <a:endParaRPr lang="en-US" sz="105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DB9815B4-3884-4F99-8505-244C5614B9B7}"/>
              </a:ext>
            </a:extLst>
          </p:cNvPr>
          <p:cNvSpPr txBox="1"/>
          <p:nvPr/>
        </p:nvSpPr>
        <p:spPr>
          <a:xfrm>
            <a:off x="2253661" y="4841568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high</a:t>
            </a:r>
            <a:endParaRPr lang="en-US" sz="1050" dirty="0"/>
          </a:p>
        </p:txBody>
      </p:sp>
      <p:pic>
        <p:nvPicPr>
          <p:cNvPr id="17" name="Picture 2" descr="Resultado de imagen para iquibicen conicet">
            <a:extLst>
              <a:ext uri="{FF2B5EF4-FFF2-40B4-BE49-F238E27FC236}">
                <a16:creationId xmlns:a16="http://schemas.microsoft.com/office/drawing/2014/main" id="{E9BAF92B-E863-4F7A-877D-E190EEC1C2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4" descr="Resultado de imagen para quimica biologica uba logo">
            <a:extLst>
              <a:ext uri="{FF2B5EF4-FFF2-40B4-BE49-F238E27FC236}">
                <a16:creationId xmlns:a16="http://schemas.microsoft.com/office/drawing/2014/main" id="{1E7438CD-EB7C-4884-B541-FD73177B437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Rectangle 7">
            <a:extLst>
              <a:ext uri="{FF2B5EF4-FFF2-40B4-BE49-F238E27FC236}">
                <a16:creationId xmlns:a16="http://schemas.microsoft.com/office/drawing/2014/main" id="{619995B5-D296-438D-8892-5B998A29A0EA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2416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Una estrella de color negro&#10;&#10;Descripción generada automáticamente con confianza baja">
            <a:extLst>
              <a:ext uri="{FF2B5EF4-FFF2-40B4-BE49-F238E27FC236}">
                <a16:creationId xmlns:a16="http://schemas.microsoft.com/office/drawing/2014/main" id="{9FDC825F-9DE0-4410-AC5D-07537DAFD2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753" y="2241857"/>
            <a:ext cx="2242800" cy="2242800"/>
          </a:xfrm>
          <a:prstGeom prst="rect">
            <a:avLst/>
          </a:prstGeom>
        </p:spPr>
      </p:pic>
      <p:graphicFrame>
        <p:nvGraphicFramePr>
          <p:cNvPr id="8" name="Gráfico 7">
            <a:extLst>
              <a:ext uri="{FF2B5EF4-FFF2-40B4-BE49-F238E27FC236}">
                <a16:creationId xmlns:a16="http://schemas.microsoft.com/office/drawing/2014/main" id="{9979272E-064E-4374-9E18-E2657852FA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4178257"/>
              </p:ext>
            </p:extLst>
          </p:nvPr>
        </p:nvGraphicFramePr>
        <p:xfrm>
          <a:off x="5624516" y="1863327"/>
          <a:ext cx="5079192" cy="31313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0" name="Imagen 9" descr="Dibujo de la cabeza&#10;&#10;Descripción generada automáticamente con confianza baja">
            <a:extLst>
              <a:ext uri="{FF2B5EF4-FFF2-40B4-BE49-F238E27FC236}">
                <a16:creationId xmlns:a16="http://schemas.microsoft.com/office/drawing/2014/main" id="{D8AC3A8B-8E4C-4DBE-8143-F164B611FC4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9039" y="2241858"/>
            <a:ext cx="2242800" cy="2242800"/>
          </a:xfrm>
          <a:prstGeom prst="rect">
            <a:avLst/>
          </a:prstGeom>
        </p:spPr>
      </p:pic>
      <p:sp>
        <p:nvSpPr>
          <p:cNvPr id="11" name="Rectangle 8">
            <a:extLst>
              <a:ext uri="{FF2B5EF4-FFF2-40B4-BE49-F238E27FC236}">
                <a16:creationId xmlns:a16="http://schemas.microsoft.com/office/drawing/2014/main" id="{448EC213-C092-4F4C-9DC1-BBDF38CCC360}"/>
              </a:ext>
            </a:extLst>
          </p:cNvPr>
          <p:cNvSpPr/>
          <p:nvPr/>
        </p:nvSpPr>
        <p:spPr>
          <a:xfrm>
            <a:off x="0" y="6525347"/>
            <a:ext cx="12191999" cy="264391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C0E8709-CCBD-4D80-8C96-F0C120C679D9}"/>
              </a:ext>
            </a:extLst>
          </p:cNvPr>
          <p:cNvSpPr txBox="1"/>
          <p:nvPr/>
        </p:nvSpPr>
        <p:spPr>
          <a:xfrm>
            <a:off x="10589766" y="6097070"/>
            <a:ext cx="1602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dirty="0" err="1"/>
              <a:t>Image</a:t>
            </a:r>
            <a:r>
              <a:rPr lang="es-AR" dirty="0"/>
              <a:t> 0033.tiff</a:t>
            </a:r>
          </a:p>
        </p:txBody>
      </p: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EE9F9EF4-6F21-4434-A646-E012279DA81F}"/>
              </a:ext>
            </a:extLst>
          </p:cNvPr>
          <p:cNvCxnSpPr/>
          <p:nvPr/>
        </p:nvCxnSpPr>
        <p:spPr>
          <a:xfrm>
            <a:off x="800099" y="4387451"/>
            <a:ext cx="496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>
            <a:extLst>
              <a:ext uri="{FF2B5EF4-FFF2-40B4-BE49-F238E27FC236}">
                <a16:creationId xmlns:a16="http://schemas.microsoft.com/office/drawing/2014/main" id="{7D776A60-DAD1-41A6-868D-ED9981187F37}"/>
              </a:ext>
            </a:extLst>
          </p:cNvPr>
          <p:cNvSpPr txBox="1"/>
          <p:nvPr/>
        </p:nvSpPr>
        <p:spPr>
          <a:xfrm>
            <a:off x="836742" y="4169805"/>
            <a:ext cx="5724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00" dirty="0">
                <a:solidFill>
                  <a:schemeClr val="bg1"/>
                </a:solidFill>
              </a:rPr>
              <a:t>5</a:t>
            </a:r>
            <a:r>
              <a:rPr lang="el-GR" sz="1000" dirty="0">
                <a:solidFill>
                  <a:schemeClr val="bg1"/>
                </a:solidFill>
              </a:rPr>
              <a:t>μ</a:t>
            </a:r>
            <a:r>
              <a:rPr lang="es-AR" sz="1000" dirty="0">
                <a:solidFill>
                  <a:schemeClr val="bg1"/>
                </a:solidFill>
              </a:rPr>
              <a:t>m</a:t>
            </a:r>
            <a:endParaRPr lang="en-US" sz="1000" dirty="0">
              <a:solidFill>
                <a:schemeClr val="bg1"/>
              </a:solidFill>
            </a:endParaRPr>
          </a:p>
        </p:txBody>
      </p:sp>
      <p:pic>
        <p:nvPicPr>
          <p:cNvPr id="16" name="Gráfico 15">
            <a:extLst>
              <a:ext uri="{FF2B5EF4-FFF2-40B4-BE49-F238E27FC236}">
                <a16:creationId xmlns:a16="http://schemas.microsoft.com/office/drawing/2014/main" id="{2F43400B-16B4-4314-AE9F-BB461CC3332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 rot="5400000">
            <a:off x="1642265" y="3912298"/>
            <a:ext cx="194796" cy="1580011"/>
          </a:xfrm>
          <a:prstGeom prst="rect">
            <a:avLst/>
          </a:prstGeom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41E59587-4B33-48E7-A6D5-AD930D48365C}"/>
              </a:ext>
            </a:extLst>
          </p:cNvPr>
          <p:cNvSpPr txBox="1"/>
          <p:nvPr/>
        </p:nvSpPr>
        <p:spPr>
          <a:xfrm>
            <a:off x="836742" y="4799702"/>
            <a:ext cx="391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low</a:t>
            </a:r>
            <a:endParaRPr lang="en-US" sz="1050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46A30808-2A3C-48B5-BB49-D22CD72BFEA0}"/>
              </a:ext>
            </a:extLst>
          </p:cNvPr>
          <p:cNvSpPr txBox="1"/>
          <p:nvPr/>
        </p:nvSpPr>
        <p:spPr>
          <a:xfrm>
            <a:off x="2188465" y="479970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high</a:t>
            </a:r>
            <a:endParaRPr lang="en-US" sz="1050" dirty="0"/>
          </a:p>
        </p:txBody>
      </p:sp>
      <p:pic>
        <p:nvPicPr>
          <p:cNvPr id="19" name="Picture 2" descr="Resultado de imagen para iquibicen conicet">
            <a:extLst>
              <a:ext uri="{FF2B5EF4-FFF2-40B4-BE49-F238E27FC236}">
                <a16:creationId xmlns:a16="http://schemas.microsoft.com/office/drawing/2014/main" id="{3FBF2A01-C893-446F-84D7-E32D9C2F29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4" descr="Resultado de imagen para quimica biologica uba logo">
            <a:extLst>
              <a:ext uri="{FF2B5EF4-FFF2-40B4-BE49-F238E27FC236}">
                <a16:creationId xmlns:a16="http://schemas.microsoft.com/office/drawing/2014/main" id="{16AB97B7-3F2B-4079-B0DF-2B536C90DA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Rectangle 7">
            <a:extLst>
              <a:ext uri="{FF2B5EF4-FFF2-40B4-BE49-F238E27FC236}">
                <a16:creationId xmlns:a16="http://schemas.microsoft.com/office/drawing/2014/main" id="{DBB54860-3BB4-4512-9CF9-6A00C47F557F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4114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Una luz verde&#10;&#10;Descripción generada automáticamente con confianza media">
            <a:extLst>
              <a:ext uri="{FF2B5EF4-FFF2-40B4-BE49-F238E27FC236}">
                <a16:creationId xmlns:a16="http://schemas.microsoft.com/office/drawing/2014/main" id="{EA732763-B98A-40C9-A4BE-FC62F7ABD0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591" y="2386017"/>
            <a:ext cx="2243133" cy="2243133"/>
          </a:xfrm>
          <a:prstGeom prst="rect">
            <a:avLst/>
          </a:prstGeom>
        </p:spPr>
      </p:pic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E513D5BA-A980-4270-BB07-FB7C801A41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2823546"/>
              </p:ext>
            </p:extLst>
          </p:nvPr>
        </p:nvGraphicFramePr>
        <p:xfrm>
          <a:off x="5667374" y="1887023"/>
          <a:ext cx="4914901" cy="3083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8" name="Imagen 7" descr="Una luz verde&#10;&#10;Descripción generada automáticamente con confianza baja">
            <a:extLst>
              <a:ext uri="{FF2B5EF4-FFF2-40B4-BE49-F238E27FC236}">
                <a16:creationId xmlns:a16="http://schemas.microsoft.com/office/drawing/2014/main" id="{77A87CAA-EDA8-4B6C-89AE-D0579F9339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5875" y="2386017"/>
            <a:ext cx="2243133" cy="224313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753627C9-97D4-4802-BF7A-B94C0901009A}"/>
              </a:ext>
            </a:extLst>
          </p:cNvPr>
          <p:cNvSpPr/>
          <p:nvPr/>
        </p:nvSpPr>
        <p:spPr>
          <a:xfrm>
            <a:off x="0" y="6525347"/>
            <a:ext cx="12191999" cy="264391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C681B4D1-182F-4553-A4F0-640B09EDD145}"/>
              </a:ext>
            </a:extLst>
          </p:cNvPr>
          <p:cNvSpPr txBox="1"/>
          <p:nvPr/>
        </p:nvSpPr>
        <p:spPr>
          <a:xfrm>
            <a:off x="10582275" y="6076950"/>
            <a:ext cx="1602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dirty="0" err="1"/>
              <a:t>Image</a:t>
            </a:r>
            <a:r>
              <a:rPr lang="es-AR" dirty="0"/>
              <a:t> 0041.tiff</a:t>
            </a:r>
          </a:p>
        </p:txBody>
      </p: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A40AFA58-F75D-408D-AB30-CDF6DC7D7E4A}"/>
              </a:ext>
            </a:extLst>
          </p:cNvPr>
          <p:cNvCxnSpPr/>
          <p:nvPr/>
        </p:nvCxnSpPr>
        <p:spPr>
          <a:xfrm>
            <a:off x="581024" y="4505325"/>
            <a:ext cx="496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>
            <a:extLst>
              <a:ext uri="{FF2B5EF4-FFF2-40B4-BE49-F238E27FC236}">
                <a16:creationId xmlns:a16="http://schemas.microsoft.com/office/drawing/2014/main" id="{1CFF11F6-6EE3-4000-8482-30D4D048FCC2}"/>
              </a:ext>
            </a:extLst>
          </p:cNvPr>
          <p:cNvSpPr txBox="1"/>
          <p:nvPr/>
        </p:nvSpPr>
        <p:spPr>
          <a:xfrm>
            <a:off x="617667" y="4259104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00" dirty="0">
                <a:solidFill>
                  <a:schemeClr val="bg1"/>
                </a:solidFill>
              </a:rPr>
              <a:t>5</a:t>
            </a:r>
            <a:r>
              <a:rPr lang="el-GR" sz="1000" dirty="0">
                <a:solidFill>
                  <a:schemeClr val="bg1"/>
                </a:solidFill>
              </a:rPr>
              <a:t>μ</a:t>
            </a:r>
            <a:r>
              <a:rPr lang="es-AR" sz="1000" dirty="0">
                <a:solidFill>
                  <a:schemeClr val="bg1"/>
                </a:solidFill>
              </a:rPr>
              <a:t>m</a:t>
            </a:r>
            <a:endParaRPr lang="en-US" sz="1000" dirty="0">
              <a:solidFill>
                <a:schemeClr val="bg1"/>
              </a:solidFill>
            </a:endParaRPr>
          </a:p>
        </p:txBody>
      </p:sp>
      <p:pic>
        <p:nvPicPr>
          <p:cNvPr id="12" name="Gráfico 11">
            <a:extLst>
              <a:ext uri="{FF2B5EF4-FFF2-40B4-BE49-F238E27FC236}">
                <a16:creationId xmlns:a16="http://schemas.microsoft.com/office/drawing/2014/main" id="{33C98741-E8FF-4731-A353-1856EEAB3F8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 rot="5400000">
            <a:off x="1546976" y="3987968"/>
            <a:ext cx="194796" cy="1580011"/>
          </a:xfrm>
          <a:prstGeom prst="rect">
            <a:avLst/>
          </a:prstGeom>
        </p:spPr>
      </p:pic>
      <p:sp>
        <p:nvSpPr>
          <p:cNvPr id="13" name="CuadroTexto 12">
            <a:extLst>
              <a:ext uri="{FF2B5EF4-FFF2-40B4-BE49-F238E27FC236}">
                <a16:creationId xmlns:a16="http://schemas.microsoft.com/office/drawing/2014/main" id="{970F0FAC-4F9D-42EF-9327-C72E45170F4F}"/>
              </a:ext>
            </a:extLst>
          </p:cNvPr>
          <p:cNvSpPr txBox="1"/>
          <p:nvPr/>
        </p:nvSpPr>
        <p:spPr>
          <a:xfrm>
            <a:off x="741453" y="4875372"/>
            <a:ext cx="391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low</a:t>
            </a:r>
            <a:endParaRPr lang="en-US" sz="105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E8C3CDC-0D5C-4203-A208-64320E3E9E90}"/>
              </a:ext>
            </a:extLst>
          </p:cNvPr>
          <p:cNvSpPr txBox="1"/>
          <p:nvPr/>
        </p:nvSpPr>
        <p:spPr>
          <a:xfrm>
            <a:off x="2093176" y="487537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/>
              <a:t>high</a:t>
            </a:r>
            <a:endParaRPr lang="en-US" sz="1050" dirty="0"/>
          </a:p>
        </p:txBody>
      </p:sp>
      <p:pic>
        <p:nvPicPr>
          <p:cNvPr id="17" name="Picture 2" descr="Resultado de imagen para iquibicen conicet">
            <a:extLst>
              <a:ext uri="{FF2B5EF4-FFF2-40B4-BE49-F238E27FC236}">
                <a16:creationId xmlns:a16="http://schemas.microsoft.com/office/drawing/2014/main" id="{78F0B535-0F6F-49DC-84A5-5535720074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4" descr="Resultado de imagen para quimica biologica uba logo">
            <a:extLst>
              <a:ext uri="{FF2B5EF4-FFF2-40B4-BE49-F238E27FC236}">
                <a16:creationId xmlns:a16="http://schemas.microsoft.com/office/drawing/2014/main" id="{3066ED70-CF11-460F-822A-05D11FC89FC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Rectangle 7">
            <a:extLst>
              <a:ext uri="{FF2B5EF4-FFF2-40B4-BE49-F238E27FC236}">
                <a16:creationId xmlns:a16="http://schemas.microsoft.com/office/drawing/2014/main" id="{43A2E2B4-D261-47FD-8E6E-DD3A9174F9C4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7575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</TotalTime>
  <Words>125</Words>
  <Application>Microsoft Office PowerPoint</Application>
  <PresentationFormat>Panorámica</PresentationFormat>
  <Paragraphs>34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mila oses</dc:creator>
  <cp:lastModifiedBy>LUMI</cp:lastModifiedBy>
  <cp:revision>10</cp:revision>
  <dcterms:created xsi:type="dcterms:W3CDTF">2021-09-29T16:09:39Z</dcterms:created>
  <dcterms:modified xsi:type="dcterms:W3CDTF">2021-10-30T23:41:51Z</dcterms:modified>
</cp:coreProperties>
</file>